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2.xml" ContentType="application/vnd.openxmlformats-officedocument.themeOverride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drawings/drawing2.xml" ContentType="application/vnd.openxmlformats-officedocument.drawingml.chartshapes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handoutMasterIdLst>
    <p:handoutMasterId r:id="rId9"/>
  </p:handoutMasterIdLst>
  <p:sldIdLst>
    <p:sldId id="272" r:id="rId2"/>
    <p:sldId id="276" r:id="rId3"/>
    <p:sldId id="275" r:id="rId4"/>
    <p:sldId id="277" r:id="rId5"/>
    <p:sldId id="273" r:id="rId6"/>
    <p:sldId id="274" r:id="rId7"/>
  </p:sldIdLst>
  <p:sldSz cx="6858000" cy="9906000" type="A4"/>
  <p:notesSz cx="9926638" cy="67976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Appendix" id="{F2D2AB2E-69BB-4AC4-B740-D58A4FF3CAC3}">
          <p14:sldIdLst>
            <p14:sldId id="272"/>
            <p14:sldId id="276"/>
            <p14:sldId id="275"/>
            <p14:sldId id="277"/>
            <p14:sldId id="273"/>
            <p14:sldId id="274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FBFBF"/>
    <a:srgbClr val="000000"/>
    <a:srgbClr val="C00000"/>
    <a:srgbClr val="F4B183"/>
    <a:srgbClr val="ADD8E6"/>
    <a:srgbClr val="97BDD9"/>
    <a:srgbClr val="81A2CC"/>
    <a:srgbClr val="6C87BF"/>
    <a:srgbClr val="566CB3"/>
    <a:srgbClr val="4051A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755" autoAdjust="0"/>
    <p:restoredTop sz="95380" autoAdjust="0"/>
  </p:normalViewPr>
  <p:slideViewPr>
    <p:cSldViewPr snapToGrid="0">
      <p:cViewPr varScale="1">
        <p:scale>
          <a:sx n="78" d="100"/>
          <a:sy n="78" d="100"/>
        </p:scale>
        <p:origin x="3270" y="102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\\ipssmonstera\guyer\1.manuscript.AG.29.03.2017\037.data\Agenda_egg%20degree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1.xml"/><Relationship Id="rId1" Type="http://schemas.microsoft.com/office/2011/relationships/chartStyle" Target="style1.xml"/><Relationship Id="rId5" Type="http://schemas.openxmlformats.org/officeDocument/2006/relationships/chartUserShapes" Target="../drawings/drawing1.xml"/><Relationship Id="rId4" Type="http://schemas.openxmlformats.org/officeDocument/2006/relationships/oleObject" Target="file:///\\ipssmonstera\guyer\1.manuscript.AG.29.03.2017\037.data\037.plant.data\037.data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2.xml"/><Relationship Id="rId2" Type="http://schemas.openxmlformats.org/officeDocument/2006/relationships/oleObject" Target="file:///H:\MS1.revision.Dec2017\stat.Jan.2018\037.data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3.xml"/><Relationship Id="rId2" Type="http://schemas.openxmlformats.org/officeDocument/2006/relationships/oleObject" Target="file:///H:\MANUSCRIPT\037.data\037.plant.data\037.data.xlsx" TargetMode="External"/><Relationship Id="rId1" Type="http://schemas.openxmlformats.org/officeDocument/2006/relationships/themeOverride" Target="../theme/themeOverrid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1"/>
          <c:order val="0"/>
          <c:tx>
            <c:strRef>
              <c:f>biomass.calc!$I$1</c:f>
              <c:strCache>
                <c:ptCount val="1"/>
                <c:pt idx="0">
                  <c:v>total FW
[g]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4"/>
            <c:spPr>
              <a:solidFill>
                <a:srgbClr val="ED7D31">
                  <a:lumMod val="60000"/>
                  <a:lumOff val="40000"/>
                </a:srgbClr>
              </a:solidFill>
              <a:ln>
                <a:solidFill>
                  <a:srgbClr val="ED7D31">
                    <a:lumMod val="60000"/>
                    <a:lumOff val="40000"/>
                  </a:srgbClr>
                </a:solidFill>
              </a:ln>
            </c:spPr>
          </c:marker>
          <c:trendline>
            <c:spPr>
              <a:ln>
                <a:noFill/>
              </a:ln>
            </c:spPr>
            <c:trendlineType val="linear"/>
            <c:dispRSqr val="1"/>
            <c:dispEq val="1"/>
            <c:trendlineLbl>
              <c:layout>
                <c:manualLayout>
                  <c:x val="-9.6466185287816641E-2"/>
                  <c:y val="1.2841503963052028E-2"/>
                </c:manualLayout>
              </c:layout>
              <c:tx>
                <c:rich>
                  <a:bodyPr/>
                  <a:lstStyle/>
                  <a:p>
                    <a:pPr>
                      <a:defRPr/>
                    </a:pPr>
                    <a:r>
                      <a:rPr lang="en-US" baseline="0" dirty="0"/>
                      <a:t>y = 1.7977x - 106.95</a:t>
                    </a:r>
                    <a:br>
                      <a:rPr lang="en-US" baseline="0" dirty="0"/>
                    </a:br>
                    <a:r>
                      <a:rPr lang="en-US" baseline="0" dirty="0"/>
                      <a:t>R² = 0.901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xVal>
            <c:numRef>
              <c:f>biomass.calc!$J$2:$J$13</c:f>
              <c:numCache>
                <c:formatCode>0.00</c:formatCode>
                <c:ptCount val="12"/>
                <c:pt idx="0">
                  <c:v>74.8</c:v>
                </c:pt>
                <c:pt idx="1">
                  <c:v>73</c:v>
                </c:pt>
                <c:pt idx="2">
                  <c:v>75.7</c:v>
                </c:pt>
                <c:pt idx="3">
                  <c:v>77.599999999999994</c:v>
                </c:pt>
                <c:pt idx="4">
                  <c:v>80</c:v>
                </c:pt>
                <c:pt idx="5">
                  <c:v>85.5</c:v>
                </c:pt>
                <c:pt idx="6">
                  <c:v>80.599999999999994</c:v>
                </c:pt>
                <c:pt idx="7">
                  <c:v>79.7</c:v>
                </c:pt>
                <c:pt idx="8">
                  <c:v>92.6</c:v>
                </c:pt>
                <c:pt idx="9">
                  <c:v>100.6</c:v>
                </c:pt>
                <c:pt idx="10">
                  <c:v>95.3</c:v>
                </c:pt>
                <c:pt idx="11">
                  <c:v>100</c:v>
                </c:pt>
              </c:numCache>
            </c:numRef>
          </c:xVal>
          <c:yVal>
            <c:numRef>
              <c:f>biomass.calc!$I$2:$I$13</c:f>
              <c:numCache>
                <c:formatCode>0.00</c:formatCode>
                <c:ptCount val="12"/>
                <c:pt idx="0">
                  <c:v>32.65</c:v>
                </c:pt>
                <c:pt idx="1">
                  <c:v>27.95</c:v>
                </c:pt>
                <c:pt idx="2">
                  <c:v>30.95</c:v>
                </c:pt>
                <c:pt idx="3">
                  <c:v>31.77</c:v>
                </c:pt>
                <c:pt idx="4">
                  <c:v>42.79</c:v>
                </c:pt>
                <c:pt idx="5">
                  <c:v>32.15</c:v>
                </c:pt>
                <c:pt idx="6">
                  <c:v>34.840000000000003</c:v>
                </c:pt>
                <c:pt idx="7">
                  <c:v>31.48</c:v>
                </c:pt>
                <c:pt idx="8">
                  <c:v>62.18</c:v>
                </c:pt>
                <c:pt idx="9">
                  <c:v>79.42</c:v>
                </c:pt>
                <c:pt idx="10">
                  <c:v>60.16</c:v>
                </c:pt>
                <c:pt idx="11">
                  <c:v>75.6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129-4D01-B391-F29CD1BCCAFD}"/>
            </c:ext>
          </c:extLst>
        </c:ser>
        <c:ser>
          <c:idx val="4"/>
          <c:order val="1"/>
          <c:tx>
            <c:v>linear</c:v>
          </c:tx>
          <c:spPr>
            <a:ln w="12700">
              <a:solidFill>
                <a:sysClr val="windowText" lastClr="000000"/>
              </a:solidFill>
            </a:ln>
          </c:spPr>
          <c:marker>
            <c:symbol val="none"/>
          </c:marker>
          <c:xVal>
            <c:numRef>
              <c:f>biomass.calc!$B$44:$B$50</c:f>
              <c:numCache>
                <c:formatCode>General</c:formatCode>
                <c:ptCount val="7"/>
                <c:pt idx="0">
                  <c:v>70</c:v>
                </c:pt>
                <c:pt idx="1">
                  <c:v>80</c:v>
                </c:pt>
                <c:pt idx="2">
                  <c:v>90</c:v>
                </c:pt>
                <c:pt idx="3">
                  <c:v>100</c:v>
                </c:pt>
                <c:pt idx="4">
                  <c:v>110</c:v>
                </c:pt>
                <c:pt idx="5">
                  <c:v>120</c:v>
                </c:pt>
                <c:pt idx="6">
                  <c:v>130</c:v>
                </c:pt>
              </c:numCache>
            </c:numRef>
          </c:xVal>
          <c:yVal>
            <c:numRef>
              <c:f>biomass.calc!$E$44:$E$50</c:f>
              <c:numCache>
                <c:formatCode>General</c:formatCode>
                <c:ptCount val="7"/>
                <c:pt idx="0">
                  <c:v>18.888999999999996</c:v>
                </c:pt>
                <c:pt idx="1">
                  <c:v>36.866</c:v>
                </c:pt>
                <c:pt idx="2">
                  <c:v>54.843000000000004</c:v>
                </c:pt>
                <c:pt idx="3">
                  <c:v>72.820000000000007</c:v>
                </c:pt>
                <c:pt idx="4">
                  <c:v>90.797000000000011</c:v>
                </c:pt>
                <c:pt idx="5">
                  <c:v>108.77400000000002</c:v>
                </c:pt>
                <c:pt idx="6">
                  <c:v>126.751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129-4D01-B391-F29CD1BCCA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4920080"/>
        <c:axId val="514920408"/>
      </c:scatterChart>
      <c:valAx>
        <c:axId val="514920080"/>
        <c:scaling>
          <c:orientation val="minMax"/>
          <c:min val="60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en-US" dirty="0"/>
                  <a:t>Plant height (c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vert="horz"/>
          <a:lstStyle/>
          <a:p>
            <a:pPr>
              <a:defRPr>
                <a:solidFill>
                  <a:schemeClr val="tx1"/>
                </a:solidFill>
              </a:defRPr>
            </a:pPr>
            <a:endParaRPr lang="en-US"/>
          </a:p>
        </c:txPr>
        <c:crossAx val="514920408"/>
        <c:crosses val="autoZero"/>
        <c:crossBetween val="midCat"/>
      </c:valAx>
      <c:valAx>
        <c:axId val="51492040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FW</a:t>
                </a:r>
                <a:r>
                  <a:rPr lang="en-US" baseline="0" dirty="0"/>
                  <a:t> total (g)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vert="horz"/>
          <a:lstStyle/>
          <a:p>
            <a:pPr>
              <a:defRPr>
                <a:solidFill>
                  <a:schemeClr val="tx1"/>
                </a:solidFill>
              </a:defRPr>
            </a:pPr>
            <a:endParaRPr lang="en-US"/>
          </a:p>
        </c:txPr>
        <c:crossAx val="51492008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7F7F7F"/>
            </a:solidFill>
            <a:ln w="635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PN.count!$K$2:$K$3</c:f>
                <c:numCache>
                  <c:formatCode>General</c:formatCode>
                  <c:ptCount val="2"/>
                  <c:pt idx="0">
                    <c:v>13.058714243139489</c:v>
                  </c:pt>
                  <c:pt idx="1">
                    <c:v>12.711300947727427</c:v>
                  </c:pt>
                </c:numCache>
              </c:numRef>
            </c:plus>
            <c:minus>
              <c:numRef>
                <c:f>EPN.count!$K$2:$K$3</c:f>
                <c:numCache>
                  <c:formatCode>General</c:formatCode>
                  <c:ptCount val="2"/>
                  <c:pt idx="0">
                    <c:v>13.058714243139489</c:v>
                  </c:pt>
                  <c:pt idx="1">
                    <c:v>12.711300947727427</c:v>
                  </c:pt>
                </c:numCache>
              </c:numRef>
            </c:minus>
            <c:spPr>
              <a:noFill/>
              <a:ln w="63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EPN.count!$I$2:$I$3</c:f>
              <c:strCache>
                <c:ptCount val="2"/>
                <c:pt idx="0">
                  <c:v>EPN-</c:v>
                </c:pt>
                <c:pt idx="1">
                  <c:v>EPN+</c:v>
                </c:pt>
              </c:strCache>
            </c:strRef>
          </c:cat>
          <c:val>
            <c:numRef>
              <c:f>EPN.count!$J$2:$J$3</c:f>
              <c:numCache>
                <c:formatCode>General</c:formatCode>
                <c:ptCount val="2"/>
                <c:pt idx="0">
                  <c:v>154.39617322393977</c:v>
                </c:pt>
                <c:pt idx="1">
                  <c:v>158.576832764633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4FF-42FA-9CD8-17D6066F0D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05835632"/>
        <c:axId val="505838912"/>
      </c:barChart>
      <c:catAx>
        <c:axId val="5058356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05838912"/>
        <c:crosses val="autoZero"/>
        <c:auto val="1"/>
        <c:lblAlgn val="ctr"/>
        <c:lblOffset val="100"/>
        <c:noMultiLvlLbl val="0"/>
      </c:catAx>
      <c:valAx>
        <c:axId val="505838912"/>
        <c:scaling>
          <c:orientation val="minMax"/>
          <c:max val="2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Nematode abundance</a:t>
                </a:r>
              </a:p>
              <a:p>
                <a:pPr>
                  <a:defRPr/>
                </a:pPr>
                <a:r>
                  <a:rPr lang="en-US" dirty="0"/>
                  <a:t>(number / 100 g dry soi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05835632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  <c:userShapes r:id="rId5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1"/>
          <c:order val="0"/>
          <c:spPr>
            <a:ln w="19050">
              <a:noFill/>
            </a:ln>
          </c:spPr>
          <c:marker>
            <c:symbol val="circle"/>
            <c:size val="4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c:spPr>
          </c:marker>
          <c:xVal>
            <c:numRef>
              <c:f>'supp.EPN.count (2)'!$F$2:$F$36</c:f>
              <c:numCache>
                <c:formatCode>General</c:formatCode>
                <c:ptCount val="35"/>
                <c:pt idx="0">
                  <c:v>7.5780074889367971E-2</c:v>
                </c:pt>
                <c:pt idx="1">
                  <c:v>7.9004195023987506E-2</c:v>
                </c:pt>
                <c:pt idx="2">
                  <c:v>8.1276690188936948E-2</c:v>
                </c:pt>
                <c:pt idx="3">
                  <c:v>8.2006408789196614E-2</c:v>
                </c:pt>
                <c:pt idx="4">
                  <c:v>8.3962924582613715E-2</c:v>
                </c:pt>
                <c:pt idx="5">
                  <c:v>8.7058931331419731E-2</c:v>
                </c:pt>
                <c:pt idx="6">
                  <c:v>8.7912219820229828E-2</c:v>
                </c:pt>
                <c:pt idx="7">
                  <c:v>8.9650907042253522E-2</c:v>
                </c:pt>
                <c:pt idx="8">
                  <c:v>9.4409345289541924E-2</c:v>
                </c:pt>
                <c:pt idx="9">
                  <c:v>9.7477298753789146E-2</c:v>
                </c:pt>
                <c:pt idx="10">
                  <c:v>0.10377092765201953</c:v>
                </c:pt>
                <c:pt idx="11">
                  <c:v>0.10599187840290382</c:v>
                </c:pt>
                <c:pt idx="12">
                  <c:v>0.11005851533325789</c:v>
                </c:pt>
                <c:pt idx="13">
                  <c:v>0.11311291243292614</c:v>
                </c:pt>
                <c:pt idx="14">
                  <c:v>0.12067237982195846</c:v>
                </c:pt>
                <c:pt idx="15">
                  <c:v>0.12461974649766511</c:v>
                </c:pt>
                <c:pt idx="16">
                  <c:v>0.12507408042037926</c:v>
                </c:pt>
                <c:pt idx="17">
                  <c:v>0.12752769931662872</c:v>
                </c:pt>
                <c:pt idx="18">
                  <c:v>0.13532261113055655</c:v>
                </c:pt>
                <c:pt idx="19">
                  <c:v>0.14498016868019148</c:v>
                </c:pt>
                <c:pt idx="20">
                  <c:v>4.9145514483354948E-2</c:v>
                </c:pt>
                <c:pt idx="21">
                  <c:v>7.0503379520108156E-2</c:v>
                </c:pt>
                <c:pt idx="22">
                  <c:v>7.4774765933446133E-2</c:v>
                </c:pt>
                <c:pt idx="23">
                  <c:v>7.6867708925525871E-2</c:v>
                </c:pt>
                <c:pt idx="24">
                  <c:v>9.3093649694030722E-2</c:v>
                </c:pt>
                <c:pt idx="25">
                  <c:v>9.5693162586031819E-2</c:v>
                </c:pt>
                <c:pt idx="26">
                  <c:v>9.588310258738085E-2</c:v>
                </c:pt>
                <c:pt idx="27">
                  <c:v>0.10589079794782229</c:v>
                </c:pt>
                <c:pt idx="28">
                  <c:v>0.10590549510935267</c:v>
                </c:pt>
                <c:pt idx="29">
                  <c:v>0.10836070482552113</c:v>
                </c:pt>
                <c:pt idx="30">
                  <c:v>0.10901318269558305</c:v>
                </c:pt>
                <c:pt idx="31">
                  <c:v>0.11288567536889897</c:v>
                </c:pt>
                <c:pt idx="32">
                  <c:v>0.1152442808219178</c:v>
                </c:pt>
                <c:pt idx="33">
                  <c:v>0.12148469444754775</c:v>
                </c:pt>
                <c:pt idx="34">
                  <c:v>0.1875099204492279</c:v>
                </c:pt>
              </c:numCache>
            </c:numRef>
          </c:xVal>
          <c:yVal>
            <c:numRef>
              <c:f>'supp.EPN.count (2)'!$G$2:$G$36</c:f>
              <c:numCache>
                <c:formatCode>General</c:formatCode>
                <c:ptCount val="35"/>
                <c:pt idx="0">
                  <c:v>222.6338883561445</c:v>
                </c:pt>
                <c:pt idx="1">
                  <c:v>152.34150270394662</c:v>
                </c:pt>
                <c:pt idx="2">
                  <c:v>71.606144011364634</c:v>
                </c:pt>
                <c:pt idx="3">
                  <c:v>44.667913938260057</c:v>
                </c:pt>
                <c:pt idx="4">
                  <c:v>211.89739053516146</c:v>
                </c:pt>
                <c:pt idx="5">
                  <c:v>127.86673705202651</c:v>
                </c:pt>
                <c:pt idx="6">
                  <c:v>141.28895184135982</c:v>
                </c:pt>
                <c:pt idx="7">
                  <c:v>111.20679756573662</c:v>
                </c:pt>
                <c:pt idx="8">
                  <c:v>54.976344839670574</c:v>
                </c:pt>
                <c:pt idx="9">
                  <c:v>154.2266841262913</c:v>
                </c:pt>
                <c:pt idx="10">
                  <c:v>116.62574535250792</c:v>
                </c:pt>
                <c:pt idx="11">
                  <c:v>130.13335688421799</c:v>
                </c:pt>
                <c:pt idx="12">
                  <c:v>119.96386630532969</c:v>
                </c:pt>
                <c:pt idx="13">
                  <c:v>23.927620097363828</c:v>
                </c:pt>
                <c:pt idx="14">
                  <c:v>118.07610677667175</c:v>
                </c:pt>
                <c:pt idx="15">
                  <c:v>124.38725490196079</c:v>
                </c:pt>
                <c:pt idx="16">
                  <c:v>247.29864705348228</c:v>
                </c:pt>
                <c:pt idx="17">
                  <c:v>110.12891344383058</c:v>
                </c:pt>
                <c:pt idx="18">
                  <c:v>219.0795186701402</c:v>
                </c:pt>
                <c:pt idx="19">
                  <c:v>0</c:v>
                </c:pt>
                <c:pt idx="20">
                  <c:v>68.379160636758328</c:v>
                </c:pt>
                <c:pt idx="21">
                  <c:v>131.50067980965329</c:v>
                </c:pt>
                <c:pt idx="22">
                  <c:v>146.68269082616868</c:v>
                </c:pt>
                <c:pt idx="23">
                  <c:v>153.65292915531336</c:v>
                </c:pt>
                <c:pt idx="24">
                  <c:v>190.59457219805265</c:v>
                </c:pt>
                <c:pt idx="25">
                  <c:v>175.94726652530656</c:v>
                </c:pt>
                <c:pt idx="26">
                  <c:v>71.877180739706915</c:v>
                </c:pt>
                <c:pt idx="27">
                  <c:v>157.12963792125606</c:v>
                </c:pt>
                <c:pt idx="28">
                  <c:v>211.14322414900451</c:v>
                </c:pt>
                <c:pt idx="29">
                  <c:v>256.73023405688838</c:v>
                </c:pt>
                <c:pt idx="30">
                  <c:v>155.61702507361471</c:v>
                </c:pt>
                <c:pt idx="31">
                  <c:v>119.87092901095605</c:v>
                </c:pt>
                <c:pt idx="32">
                  <c:v>140.50506826038554</c:v>
                </c:pt>
                <c:pt idx="33">
                  <c:v>100.62448450571463</c:v>
                </c:pt>
                <c:pt idx="34">
                  <c:v>70.2027345591702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150-4575-AA2C-6B9787473BE2}"/>
            </c:ext>
          </c:extLst>
        </c:ser>
        <c:ser>
          <c:idx val="4"/>
          <c:order val="1"/>
          <c:spPr>
            <a:ln w="19050">
              <a:noFill/>
            </a:ln>
          </c:spPr>
          <c:marker>
            <c:symbol val="circle"/>
            <c:size val="4"/>
            <c:spPr>
              <a:solidFill>
                <a:srgbClr val="C00000"/>
              </a:solidFill>
              <a:ln>
                <a:solidFill>
                  <a:srgbClr val="C00000"/>
                </a:solidFill>
              </a:ln>
            </c:spPr>
          </c:marker>
          <c:xVal>
            <c:numRef>
              <c:f>'supp.EPN.count (2)'!$F$37:$F$57</c:f>
              <c:numCache>
                <c:formatCode>General</c:formatCode>
                <c:ptCount val="21"/>
                <c:pt idx="0">
                  <c:v>3.5834822271154455E-2</c:v>
                </c:pt>
                <c:pt idx="1">
                  <c:v>5.9789072553805181E-2</c:v>
                </c:pt>
                <c:pt idx="2">
                  <c:v>6.890087591240876E-2</c:v>
                </c:pt>
                <c:pt idx="3">
                  <c:v>8.1050234258941839E-2</c:v>
                </c:pt>
                <c:pt idx="4">
                  <c:v>8.5442479469006641E-2</c:v>
                </c:pt>
                <c:pt idx="5">
                  <c:v>9.1108465363709951E-2</c:v>
                </c:pt>
                <c:pt idx="6">
                  <c:v>9.3268444444444445E-2</c:v>
                </c:pt>
                <c:pt idx="7">
                  <c:v>9.695253948414953E-2</c:v>
                </c:pt>
                <c:pt idx="8">
                  <c:v>0.10828896413900299</c:v>
                </c:pt>
                <c:pt idx="9">
                  <c:v>0.11427219480092136</c:v>
                </c:pt>
                <c:pt idx="10">
                  <c:v>0.11737765514134472</c:v>
                </c:pt>
                <c:pt idx="11">
                  <c:v>0.13379139420831385</c:v>
                </c:pt>
                <c:pt idx="12">
                  <c:v>0.15940383631713556</c:v>
                </c:pt>
                <c:pt idx="13">
                  <c:v>0.17319410190786411</c:v>
                </c:pt>
                <c:pt idx="14">
                  <c:v>6.1436159323542509E-2</c:v>
                </c:pt>
                <c:pt idx="15">
                  <c:v>6.8204656552886642E-2</c:v>
                </c:pt>
                <c:pt idx="16">
                  <c:v>8.386411253430924E-2</c:v>
                </c:pt>
                <c:pt idx="17">
                  <c:v>0.10443611865942029</c:v>
                </c:pt>
                <c:pt idx="18">
                  <c:v>0.11552079595123074</c:v>
                </c:pt>
                <c:pt idx="19">
                  <c:v>0.11935393700787403</c:v>
                </c:pt>
                <c:pt idx="20">
                  <c:v>0.12934766729500471</c:v>
                </c:pt>
              </c:numCache>
            </c:numRef>
          </c:xVal>
          <c:yVal>
            <c:numRef>
              <c:f>'supp.EPN.count (2)'!$G$37:$G$57</c:f>
              <c:numCache>
                <c:formatCode>General</c:formatCode>
                <c:ptCount val="21"/>
                <c:pt idx="0">
                  <c:v>413.50537634408607</c:v>
                </c:pt>
                <c:pt idx="1">
                  <c:v>94.019326194828949</c:v>
                </c:pt>
                <c:pt idx="2">
                  <c:v>128.06131186847063</c:v>
                </c:pt>
                <c:pt idx="3">
                  <c:v>71.409539035438314</c:v>
                </c:pt>
                <c:pt idx="4">
                  <c:v>179.60233714136217</c:v>
                </c:pt>
                <c:pt idx="5">
                  <c:v>144.28713139146902</c:v>
                </c:pt>
                <c:pt idx="6">
                  <c:v>262.34701848797852</c:v>
                </c:pt>
                <c:pt idx="7">
                  <c:v>183.5386691938773</c:v>
                </c:pt>
                <c:pt idx="8">
                  <c:v>268.90856512536152</c:v>
                </c:pt>
                <c:pt idx="9">
                  <c:v>365.66762383345298</c:v>
                </c:pt>
                <c:pt idx="10">
                  <c:v>27.834699453551913</c:v>
                </c:pt>
                <c:pt idx="11">
                  <c:v>0</c:v>
                </c:pt>
                <c:pt idx="12">
                  <c:v>45.501300901555027</c:v>
                </c:pt>
                <c:pt idx="13">
                  <c:v>159.71506233011527</c:v>
                </c:pt>
                <c:pt idx="14">
                  <c:v>99.854414661299998</c:v>
                </c:pt>
                <c:pt idx="15">
                  <c:v>175.16642891107946</c:v>
                </c:pt>
                <c:pt idx="16">
                  <c:v>104.86812570145905</c:v>
                </c:pt>
                <c:pt idx="17">
                  <c:v>281.25554176272385</c:v>
                </c:pt>
                <c:pt idx="18">
                  <c:v>144.79963980189106</c:v>
                </c:pt>
                <c:pt idx="19">
                  <c:v>128.98736887176193</c:v>
                </c:pt>
                <c:pt idx="20">
                  <c:v>181.418034737092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150-4575-AA2C-6B9787473BE2}"/>
            </c:ext>
          </c:extLst>
        </c:ser>
        <c:ser>
          <c:idx val="3"/>
          <c:order val="2"/>
          <c:spPr>
            <a:ln w="19050">
              <a:noFill/>
            </a:ln>
          </c:spPr>
          <c:marker>
            <c:symbol val="circle"/>
            <c:size val="4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bg1">
                    <a:lumMod val="75000"/>
                  </a:schemeClr>
                </a:solidFill>
              </a:ln>
            </c:spPr>
          </c:marker>
          <c:xVal>
            <c:numRef>
              <c:f>'supp.EPN.count (2)'!$F$58:$F$80</c:f>
              <c:numCache>
                <c:formatCode>General</c:formatCode>
                <c:ptCount val="23"/>
                <c:pt idx="0">
                  <c:v>8.7514529816513767E-2</c:v>
                </c:pt>
                <c:pt idx="1">
                  <c:v>8.8794142921754859E-2</c:v>
                </c:pt>
                <c:pt idx="2">
                  <c:v>9.3015060240963857E-2</c:v>
                </c:pt>
                <c:pt idx="3">
                  <c:v>9.6959645131938124E-2</c:v>
                </c:pt>
                <c:pt idx="4">
                  <c:v>9.8350112917795843E-2</c:v>
                </c:pt>
                <c:pt idx="5">
                  <c:v>9.9053037713292033E-2</c:v>
                </c:pt>
                <c:pt idx="6">
                  <c:v>0.11013832207207207</c:v>
                </c:pt>
                <c:pt idx="7">
                  <c:v>0.12064427498292737</c:v>
                </c:pt>
                <c:pt idx="8">
                  <c:v>0.15375961095764271</c:v>
                </c:pt>
                <c:pt idx="9">
                  <c:v>7.6750119767309222E-2</c:v>
                </c:pt>
                <c:pt idx="10">
                  <c:v>7.7779019104010735E-2</c:v>
                </c:pt>
                <c:pt idx="11">
                  <c:v>7.8822003797609744E-2</c:v>
                </c:pt>
                <c:pt idx="12">
                  <c:v>7.9080140313005934E-2</c:v>
                </c:pt>
                <c:pt idx="13">
                  <c:v>8.0802189531303456E-2</c:v>
                </c:pt>
                <c:pt idx="14">
                  <c:v>8.7568655229662423E-2</c:v>
                </c:pt>
                <c:pt idx="15">
                  <c:v>9.0149678206835324E-2</c:v>
                </c:pt>
                <c:pt idx="16">
                  <c:v>9.2192299181234796E-2</c:v>
                </c:pt>
                <c:pt idx="17">
                  <c:v>9.6900160734787605E-2</c:v>
                </c:pt>
                <c:pt idx="18">
                  <c:v>0.11987210938386475</c:v>
                </c:pt>
                <c:pt idx="19">
                  <c:v>0.12609330762250454</c:v>
                </c:pt>
                <c:pt idx="20">
                  <c:v>0.13955945177434029</c:v>
                </c:pt>
                <c:pt idx="21">
                  <c:v>0.14066561715719825</c:v>
                </c:pt>
                <c:pt idx="22">
                  <c:v>0.1695149461610487</c:v>
                </c:pt>
              </c:numCache>
            </c:numRef>
          </c:xVal>
          <c:yVal>
            <c:numRef>
              <c:f>'supp.EPN.count (2)'!$G$58:$G$80</c:f>
              <c:numCache>
                <c:formatCode>General</c:formatCode>
                <c:ptCount val="23"/>
                <c:pt idx="0">
                  <c:v>136.78709384230859</c:v>
                </c:pt>
                <c:pt idx="1">
                  <c:v>78.926246321234288</c:v>
                </c:pt>
                <c:pt idx="2">
                  <c:v>142.27429647452664</c:v>
                </c:pt>
                <c:pt idx="3">
                  <c:v>430.64755313890259</c:v>
                </c:pt>
                <c:pt idx="4">
                  <c:v>130.81334878606879</c:v>
                </c:pt>
                <c:pt idx="5">
                  <c:v>164.89187173750935</c:v>
                </c:pt>
                <c:pt idx="6">
                  <c:v>204.2981501632209</c:v>
                </c:pt>
                <c:pt idx="7">
                  <c:v>235.57356646328506</c:v>
                </c:pt>
                <c:pt idx="8">
                  <c:v>118.62396204033215</c:v>
                </c:pt>
                <c:pt idx="9">
                  <c:v>254.04487351390009</c:v>
                </c:pt>
                <c:pt idx="10">
                  <c:v>69.187220847202084</c:v>
                </c:pt>
                <c:pt idx="11">
                  <c:v>233.77562658210246</c:v>
                </c:pt>
                <c:pt idx="12">
                  <c:v>129.30109997855192</c:v>
                </c:pt>
                <c:pt idx="13">
                  <c:v>535.75989782886336</c:v>
                </c:pt>
                <c:pt idx="14">
                  <c:v>163.21340846698453</c:v>
                </c:pt>
                <c:pt idx="15">
                  <c:v>93.467758874186103</c:v>
                </c:pt>
                <c:pt idx="16">
                  <c:v>249.16536494226472</c:v>
                </c:pt>
                <c:pt idx="17">
                  <c:v>500.46533969797957</c:v>
                </c:pt>
                <c:pt idx="18">
                  <c:v>83.777084098420858</c:v>
                </c:pt>
                <c:pt idx="19">
                  <c:v>87.488908606921029</c:v>
                </c:pt>
                <c:pt idx="20">
                  <c:v>126.93106875056463</c:v>
                </c:pt>
                <c:pt idx="21">
                  <c:v>180.15514100873065</c:v>
                </c:pt>
                <c:pt idx="22">
                  <c:v>83.39681330540216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150-4575-AA2C-6B9787473BE2}"/>
            </c:ext>
          </c:extLst>
        </c:ser>
        <c:ser>
          <c:idx val="0"/>
          <c:order val="3"/>
          <c:spPr>
            <a:ln w="19050">
              <a:noFill/>
            </a:ln>
          </c:spPr>
          <c:marker>
            <c:symbol val="circle"/>
            <c:size val="4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  <a:effectLst/>
            </c:spPr>
          </c:marker>
          <c:xVal>
            <c:numRef>
              <c:f>'supp.EPN.count (2)'!$F$81:$F$118</c:f>
              <c:numCache>
                <c:formatCode>General</c:formatCode>
                <c:ptCount val="38"/>
                <c:pt idx="0">
                  <c:v>5.214198506331854E-2</c:v>
                </c:pt>
                <c:pt idx="1">
                  <c:v>6.8264184636118594E-2</c:v>
                </c:pt>
                <c:pt idx="2">
                  <c:v>8.64300474790866E-2</c:v>
                </c:pt>
                <c:pt idx="3">
                  <c:v>9.0536659784354212E-2</c:v>
                </c:pt>
                <c:pt idx="4">
                  <c:v>9.2969834945930571E-2</c:v>
                </c:pt>
                <c:pt idx="5">
                  <c:v>9.3421057307863167E-2</c:v>
                </c:pt>
                <c:pt idx="6">
                  <c:v>0.10197073008849557</c:v>
                </c:pt>
                <c:pt idx="7">
                  <c:v>0.10599086045982244</c:v>
                </c:pt>
                <c:pt idx="8">
                  <c:v>0.10908661898719577</c:v>
                </c:pt>
                <c:pt idx="9">
                  <c:v>0.11459339309428952</c:v>
                </c:pt>
                <c:pt idx="10">
                  <c:v>0.12114365318176752</c:v>
                </c:pt>
                <c:pt idx="11">
                  <c:v>0.12188348987212855</c:v>
                </c:pt>
                <c:pt idx="12">
                  <c:v>0.12666953990820554</c:v>
                </c:pt>
                <c:pt idx="13">
                  <c:v>0.12910615208690682</c:v>
                </c:pt>
                <c:pt idx="14">
                  <c:v>0.13375609475620975</c:v>
                </c:pt>
                <c:pt idx="15">
                  <c:v>0.14967950484643233</c:v>
                </c:pt>
                <c:pt idx="16">
                  <c:v>2.9540810002137211E-2</c:v>
                </c:pt>
                <c:pt idx="17">
                  <c:v>5.2628846758143923E-2</c:v>
                </c:pt>
                <c:pt idx="18">
                  <c:v>6.6241363483712082E-2</c:v>
                </c:pt>
                <c:pt idx="19">
                  <c:v>7.0765983560409862E-2</c:v>
                </c:pt>
                <c:pt idx="20">
                  <c:v>8.0408437779767236E-2</c:v>
                </c:pt>
                <c:pt idx="21">
                  <c:v>8.1230581882301076E-2</c:v>
                </c:pt>
                <c:pt idx="22">
                  <c:v>8.3327112434165324E-2</c:v>
                </c:pt>
                <c:pt idx="23">
                  <c:v>8.5173017873510531E-2</c:v>
                </c:pt>
                <c:pt idx="24">
                  <c:v>8.9187722132471725E-2</c:v>
                </c:pt>
                <c:pt idx="25">
                  <c:v>8.9699026819056241E-2</c:v>
                </c:pt>
                <c:pt idx="26">
                  <c:v>9.0340733634311512E-2</c:v>
                </c:pt>
                <c:pt idx="27">
                  <c:v>9.2074182969580462E-2</c:v>
                </c:pt>
                <c:pt idx="28">
                  <c:v>9.2910889655940326E-2</c:v>
                </c:pt>
                <c:pt idx="29">
                  <c:v>0.10058106891377121</c:v>
                </c:pt>
                <c:pt idx="30">
                  <c:v>0.1058522567475618</c:v>
                </c:pt>
                <c:pt idx="31">
                  <c:v>0.11283355764917004</c:v>
                </c:pt>
                <c:pt idx="32">
                  <c:v>0.11329880125476137</c:v>
                </c:pt>
                <c:pt idx="33">
                  <c:v>0.11528761809492052</c:v>
                </c:pt>
                <c:pt idx="34">
                  <c:v>0.12312791889483067</c:v>
                </c:pt>
                <c:pt idx="35">
                  <c:v>0.13665410214929513</c:v>
                </c:pt>
                <c:pt idx="36">
                  <c:v>0.13768623344277142</c:v>
                </c:pt>
                <c:pt idx="37">
                  <c:v>0.15499232997335188</c:v>
                </c:pt>
              </c:numCache>
            </c:numRef>
          </c:xVal>
          <c:yVal>
            <c:numRef>
              <c:f>'supp.EPN.count (2)'!$G$81:$G$118</c:f>
              <c:numCache>
                <c:formatCode>General</c:formatCode>
                <c:ptCount val="38"/>
                <c:pt idx="0">
                  <c:v>79.676314970432628</c:v>
                </c:pt>
                <c:pt idx="1">
                  <c:v>238.08299774369522</c:v>
                </c:pt>
                <c:pt idx="2">
                  <c:v>16.424961546912769</c:v>
                </c:pt>
                <c:pt idx="3">
                  <c:v>123.33099086437105</c:v>
                </c:pt>
                <c:pt idx="4">
                  <c:v>97.520755146138981</c:v>
                </c:pt>
                <c:pt idx="5">
                  <c:v>139.01433339878264</c:v>
                </c:pt>
                <c:pt idx="6">
                  <c:v>323.60537190082653</c:v>
                </c:pt>
                <c:pt idx="7">
                  <c:v>135.67328918322298</c:v>
                </c:pt>
                <c:pt idx="8">
                  <c:v>111.47438891483732</c:v>
                </c:pt>
                <c:pt idx="9">
                  <c:v>115.05078485687905</c:v>
                </c:pt>
                <c:pt idx="10">
                  <c:v>175.35777298568908</c:v>
                </c:pt>
                <c:pt idx="11">
                  <c:v>433.75299760191848</c:v>
                </c:pt>
                <c:pt idx="12">
                  <c:v>152.18188485515219</c:v>
                </c:pt>
                <c:pt idx="13">
                  <c:v>306.95477075588605</c:v>
                </c:pt>
                <c:pt idx="14">
                  <c:v>152.32429441062533</c:v>
                </c:pt>
                <c:pt idx="15">
                  <c:v>19.380876352669862</c:v>
                </c:pt>
                <c:pt idx="16">
                  <c:v>110.78312206980377</c:v>
                </c:pt>
                <c:pt idx="17">
                  <c:v>161.97798357504806</c:v>
                </c:pt>
                <c:pt idx="18">
                  <c:v>166.37230660543977</c:v>
                </c:pt>
                <c:pt idx="19">
                  <c:v>438.43283582089549</c:v>
                </c:pt>
                <c:pt idx="20">
                  <c:v>53.273257354890013</c:v>
                </c:pt>
                <c:pt idx="21">
                  <c:v>83.340857787810393</c:v>
                </c:pt>
                <c:pt idx="22">
                  <c:v>266.53781955547748</c:v>
                </c:pt>
                <c:pt idx="23">
                  <c:v>107.54966887417218</c:v>
                </c:pt>
                <c:pt idx="24">
                  <c:v>147.57947976878614</c:v>
                </c:pt>
                <c:pt idx="25">
                  <c:v>161.30251490042158</c:v>
                </c:pt>
                <c:pt idx="26">
                  <c:v>220.15126958400865</c:v>
                </c:pt>
                <c:pt idx="27">
                  <c:v>104.17621360706322</c:v>
                </c:pt>
                <c:pt idx="28">
                  <c:v>102.30873698506112</c:v>
                </c:pt>
                <c:pt idx="29">
                  <c:v>88.615449812325949</c:v>
                </c:pt>
                <c:pt idx="30">
                  <c:v>96.165191740412979</c:v>
                </c:pt>
                <c:pt idx="31">
                  <c:v>172.71369586225072</c:v>
                </c:pt>
                <c:pt idx="32">
                  <c:v>54.356514788169463</c:v>
                </c:pt>
                <c:pt idx="33">
                  <c:v>78.930617441120305</c:v>
                </c:pt>
                <c:pt idx="34">
                  <c:v>108.14014346848928</c:v>
                </c:pt>
                <c:pt idx="35">
                  <c:v>118.84195538680589</c:v>
                </c:pt>
                <c:pt idx="36">
                  <c:v>114.62556173596055</c:v>
                </c:pt>
                <c:pt idx="37">
                  <c:v>184.344125246998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150-4575-AA2C-6B9787473B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4920080"/>
        <c:axId val="514920408"/>
      </c:scatterChart>
      <c:valAx>
        <c:axId val="514920080"/>
        <c:scaling>
          <c:orientation val="minMax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de-CH"/>
                  <a:t>Soil water content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%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514920408"/>
        <c:crosses val="autoZero"/>
        <c:crossBetween val="midCat"/>
        <c:majorUnit val="5.000000000000001E-2"/>
      </c:valAx>
      <c:valAx>
        <c:axId val="51492040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de-CH"/>
                  <a:t>Nematode abundance</a:t>
                </a:r>
              </a:p>
              <a:p>
                <a:pPr>
                  <a:defRPr/>
                </a:pPr>
                <a:r>
                  <a:rPr lang="de-CH"/>
                  <a:t>(number / 100 g dry soi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51492008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  <c:userShapes r:id="rId3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1"/>
          <c:order val="0"/>
          <c:tx>
            <c:strRef>
              <c:f>ASI!$G$2</c:f>
              <c:strCache>
                <c:ptCount val="1"/>
                <c:pt idx="0">
                  <c:v>WCR-.ant-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4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c:spPr>
          </c:marker>
          <c:xVal>
            <c:numRef>
              <c:f>ASI!$H$2:$H$36</c:f>
              <c:numCache>
                <c:formatCode>General</c:formatCode>
                <c:ptCount val="35"/>
                <c:pt idx="0">
                  <c:v>7.5780074889367971E-2</c:v>
                </c:pt>
                <c:pt idx="1">
                  <c:v>4.9145514483354948E-2</c:v>
                </c:pt>
                <c:pt idx="2">
                  <c:v>7.6867708925525871E-2</c:v>
                </c:pt>
                <c:pt idx="3">
                  <c:v>7.4774765933446133E-2</c:v>
                </c:pt>
                <c:pt idx="4">
                  <c:v>7.0503379520108156E-2</c:v>
                </c:pt>
                <c:pt idx="5">
                  <c:v>9.4409345289541924E-2</c:v>
                </c:pt>
                <c:pt idx="6">
                  <c:v>9.7477298753789146E-2</c:v>
                </c:pt>
                <c:pt idx="7">
                  <c:v>8.7058931331419731E-2</c:v>
                </c:pt>
                <c:pt idx="8">
                  <c:v>8.7912219820229828E-2</c:v>
                </c:pt>
                <c:pt idx="9">
                  <c:v>8.9650907042253522E-2</c:v>
                </c:pt>
                <c:pt idx="10">
                  <c:v>7.9004195023987506E-2</c:v>
                </c:pt>
                <c:pt idx="11">
                  <c:v>8.2006408789196614E-2</c:v>
                </c:pt>
                <c:pt idx="12">
                  <c:v>8.3962924582613715E-2</c:v>
                </c:pt>
                <c:pt idx="13">
                  <c:v>8.1276690188936948E-2</c:v>
                </c:pt>
                <c:pt idx="14">
                  <c:v>9.5693162586031819E-2</c:v>
                </c:pt>
                <c:pt idx="15">
                  <c:v>9.588310258738085E-2</c:v>
                </c:pt>
                <c:pt idx="16">
                  <c:v>9.3093649694030722E-2</c:v>
                </c:pt>
                <c:pt idx="17">
                  <c:v>0.12461974649766511</c:v>
                </c:pt>
                <c:pt idx="18">
                  <c:v>0.12507408042037926</c:v>
                </c:pt>
                <c:pt idx="19">
                  <c:v>0.11005851533325789</c:v>
                </c:pt>
                <c:pt idx="20">
                  <c:v>0.10377092765201953</c:v>
                </c:pt>
                <c:pt idx="21">
                  <c:v>0.11311291243292614</c:v>
                </c:pt>
                <c:pt idx="22">
                  <c:v>0.10599187840290382</c:v>
                </c:pt>
                <c:pt idx="23">
                  <c:v>0.12067237982195846</c:v>
                </c:pt>
                <c:pt idx="24">
                  <c:v>0.10589079794782229</c:v>
                </c:pt>
                <c:pt idx="25">
                  <c:v>0.12148469444754775</c:v>
                </c:pt>
                <c:pt idx="26">
                  <c:v>0.10590549510935267</c:v>
                </c:pt>
                <c:pt idx="27">
                  <c:v>0.1152442808219178</c:v>
                </c:pt>
                <c:pt idx="28">
                  <c:v>0.10901318269558305</c:v>
                </c:pt>
                <c:pt idx="29">
                  <c:v>0.11288567536889897</c:v>
                </c:pt>
                <c:pt idx="30">
                  <c:v>0.10836070482552113</c:v>
                </c:pt>
                <c:pt idx="31">
                  <c:v>0.14498016868019148</c:v>
                </c:pt>
                <c:pt idx="32">
                  <c:v>0.12752769931662872</c:v>
                </c:pt>
                <c:pt idx="33">
                  <c:v>0.13532261113055655</c:v>
                </c:pt>
                <c:pt idx="34">
                  <c:v>0.1875099204492279</c:v>
                </c:pt>
              </c:numCache>
            </c:numRef>
          </c:xVal>
          <c:yVal>
            <c:numRef>
              <c:f>ASI!$I$2:$I$36</c:f>
              <c:numCache>
                <c:formatCode>General</c:formatCode>
                <c:ptCount val="35"/>
                <c:pt idx="0">
                  <c:v>3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4</c:v>
                </c:pt>
                <c:pt idx="5">
                  <c:v>4</c:v>
                </c:pt>
                <c:pt idx="6">
                  <c:v>4</c:v>
                </c:pt>
                <c:pt idx="7">
                  <c:v>3</c:v>
                </c:pt>
                <c:pt idx="8">
                  <c:v>3</c:v>
                </c:pt>
                <c:pt idx="9">
                  <c:v>3</c:v>
                </c:pt>
                <c:pt idx="10">
                  <c:v>5</c:v>
                </c:pt>
                <c:pt idx="11">
                  <c:v>3</c:v>
                </c:pt>
                <c:pt idx="12">
                  <c:v>0</c:v>
                </c:pt>
                <c:pt idx="13">
                  <c:v>5</c:v>
                </c:pt>
                <c:pt idx="14">
                  <c:v>3</c:v>
                </c:pt>
                <c:pt idx="15">
                  <c:v>4</c:v>
                </c:pt>
                <c:pt idx="16">
                  <c:v>2</c:v>
                </c:pt>
                <c:pt idx="17">
                  <c:v>3</c:v>
                </c:pt>
                <c:pt idx="18">
                  <c:v>0</c:v>
                </c:pt>
                <c:pt idx="19">
                  <c:v>3</c:v>
                </c:pt>
                <c:pt idx="20">
                  <c:v>4</c:v>
                </c:pt>
                <c:pt idx="21">
                  <c:v>1</c:v>
                </c:pt>
                <c:pt idx="22">
                  <c:v>4</c:v>
                </c:pt>
                <c:pt idx="23">
                  <c:v>4</c:v>
                </c:pt>
                <c:pt idx="24">
                  <c:v>4</c:v>
                </c:pt>
                <c:pt idx="25">
                  <c:v>4</c:v>
                </c:pt>
                <c:pt idx="26">
                  <c:v>3</c:v>
                </c:pt>
                <c:pt idx="27">
                  <c:v>0</c:v>
                </c:pt>
                <c:pt idx="28">
                  <c:v>1</c:v>
                </c:pt>
                <c:pt idx="29">
                  <c:v>2</c:v>
                </c:pt>
                <c:pt idx="30">
                  <c:v>4</c:v>
                </c:pt>
                <c:pt idx="31">
                  <c:v>1</c:v>
                </c:pt>
                <c:pt idx="32">
                  <c:v>3</c:v>
                </c:pt>
                <c:pt idx="33">
                  <c:v>4</c:v>
                </c:pt>
                <c:pt idx="34">
                  <c:v>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693-49A4-884C-34F680F4564B}"/>
            </c:ext>
          </c:extLst>
        </c:ser>
        <c:ser>
          <c:idx val="4"/>
          <c:order val="1"/>
          <c:tx>
            <c:strRef>
              <c:f>ASI!$G$62</c:f>
              <c:strCache>
                <c:ptCount val="1"/>
                <c:pt idx="0">
                  <c:v>WCR+.ant-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4"/>
            <c:spPr>
              <a:solidFill>
                <a:srgbClr val="C00000"/>
              </a:solidFill>
              <a:ln>
                <a:solidFill>
                  <a:srgbClr val="C00000"/>
                </a:solidFill>
              </a:ln>
            </c:spPr>
          </c:marker>
          <c:xVal>
            <c:numRef>
              <c:f>ASI!$H$62:$H$82</c:f>
              <c:numCache>
                <c:formatCode>General</c:formatCode>
                <c:ptCount val="21"/>
                <c:pt idx="0">
                  <c:v>6.890087591240876E-2</c:v>
                </c:pt>
                <c:pt idx="1">
                  <c:v>5.9789072553805181E-2</c:v>
                </c:pt>
                <c:pt idx="2">
                  <c:v>6.8204656552886642E-2</c:v>
                </c:pt>
                <c:pt idx="3">
                  <c:v>3.5834822271154455E-2</c:v>
                </c:pt>
                <c:pt idx="4">
                  <c:v>9.3268444444444445E-2</c:v>
                </c:pt>
                <c:pt idx="5">
                  <c:v>9.695253948414953E-2</c:v>
                </c:pt>
                <c:pt idx="6">
                  <c:v>8.5442479469006641E-2</c:v>
                </c:pt>
                <c:pt idx="7">
                  <c:v>9.1108465363709951E-2</c:v>
                </c:pt>
                <c:pt idx="8">
                  <c:v>8.1050234258941839E-2</c:v>
                </c:pt>
                <c:pt idx="9">
                  <c:v>8.386411253430924E-2</c:v>
                </c:pt>
                <c:pt idx="10">
                  <c:v>6.1436159323542509E-2</c:v>
                </c:pt>
                <c:pt idx="11">
                  <c:v>0.11427219480092136</c:v>
                </c:pt>
                <c:pt idx="12">
                  <c:v>0.10828896413900299</c:v>
                </c:pt>
                <c:pt idx="13">
                  <c:v>0.11737765514134472</c:v>
                </c:pt>
                <c:pt idx="14">
                  <c:v>0.11935393700787403</c:v>
                </c:pt>
                <c:pt idx="15">
                  <c:v>0.11552079595123074</c:v>
                </c:pt>
                <c:pt idx="16">
                  <c:v>0.10443611865942029</c:v>
                </c:pt>
                <c:pt idx="17">
                  <c:v>0.17319410190786411</c:v>
                </c:pt>
                <c:pt idx="18">
                  <c:v>0.15940383631713556</c:v>
                </c:pt>
                <c:pt idx="19">
                  <c:v>0.13379139420831385</c:v>
                </c:pt>
                <c:pt idx="20">
                  <c:v>0.12934766729500471</c:v>
                </c:pt>
              </c:numCache>
            </c:numRef>
          </c:xVal>
          <c:yVal>
            <c:numRef>
              <c:f>ASI!$I$62:$I$82</c:f>
              <c:numCache>
                <c:formatCode>General</c:formatCode>
                <c:ptCount val="21"/>
                <c:pt idx="0">
                  <c:v>5</c:v>
                </c:pt>
                <c:pt idx="1">
                  <c:v>5</c:v>
                </c:pt>
                <c:pt idx="2">
                  <c:v>7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4</c:v>
                </c:pt>
                <c:pt idx="7">
                  <c:v>1</c:v>
                </c:pt>
                <c:pt idx="8">
                  <c:v>4</c:v>
                </c:pt>
                <c:pt idx="9">
                  <c:v>4</c:v>
                </c:pt>
                <c:pt idx="10">
                  <c:v>4</c:v>
                </c:pt>
                <c:pt idx="11">
                  <c:v>4</c:v>
                </c:pt>
                <c:pt idx="12">
                  <c:v>3</c:v>
                </c:pt>
                <c:pt idx="13">
                  <c:v>4</c:v>
                </c:pt>
                <c:pt idx="14">
                  <c:v>3</c:v>
                </c:pt>
                <c:pt idx="15">
                  <c:v>2</c:v>
                </c:pt>
                <c:pt idx="16">
                  <c:v>4</c:v>
                </c:pt>
                <c:pt idx="17">
                  <c:v>1</c:v>
                </c:pt>
                <c:pt idx="18">
                  <c:v>1</c:v>
                </c:pt>
                <c:pt idx="19">
                  <c:v>0</c:v>
                </c:pt>
                <c:pt idx="20">
                  <c:v>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693-49A4-884C-34F680F4564B}"/>
            </c:ext>
          </c:extLst>
        </c:ser>
        <c:ser>
          <c:idx val="3"/>
          <c:order val="2"/>
          <c:tx>
            <c:strRef>
              <c:f>ASI!$G$37</c:f>
              <c:strCache>
                <c:ptCount val="1"/>
                <c:pt idx="0">
                  <c:v>WCR-.ant+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4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bg1">
                    <a:lumMod val="75000"/>
                  </a:schemeClr>
                </a:solidFill>
              </a:ln>
            </c:spPr>
          </c:marker>
          <c:dPt>
            <c:idx val="22"/>
            <c:marker>
              <c:symbol val="none"/>
            </c:marker>
            <c:bubble3D val="0"/>
            <c:extLst>
              <c:ext xmlns:c16="http://schemas.microsoft.com/office/drawing/2014/chart" uri="{C3380CC4-5D6E-409C-BE32-E72D297353CC}">
                <c16:uniqueId val="{00000002-4693-49A4-884C-34F680F4564B}"/>
              </c:ext>
            </c:extLst>
          </c:dPt>
          <c:xVal>
            <c:numRef>
              <c:f>(ASI!$H$37:$H$52,ASI!$H$54:$H$59,ASI!$H$61)</c:f>
              <c:numCache>
                <c:formatCode>General</c:formatCode>
                <c:ptCount val="23"/>
                <c:pt idx="0">
                  <c:v>7.9080140313005934E-2</c:v>
                </c:pt>
                <c:pt idx="1">
                  <c:v>7.7779019104010735E-2</c:v>
                </c:pt>
                <c:pt idx="2">
                  <c:v>9.9053037713292033E-2</c:v>
                </c:pt>
                <c:pt idx="3">
                  <c:v>9.6959645131938124E-2</c:v>
                </c:pt>
                <c:pt idx="4">
                  <c:v>9.3015060240963857E-2</c:v>
                </c:pt>
                <c:pt idx="5">
                  <c:v>8.8794142921754859E-2</c:v>
                </c:pt>
                <c:pt idx="6">
                  <c:v>8.7514529816513767E-2</c:v>
                </c:pt>
                <c:pt idx="7">
                  <c:v>9.2192299181234796E-2</c:v>
                </c:pt>
                <c:pt idx="8">
                  <c:v>9.0149678206835324E-2</c:v>
                </c:pt>
                <c:pt idx="9">
                  <c:v>8.7568655229662423E-2</c:v>
                </c:pt>
                <c:pt idx="10">
                  <c:v>9.6900160734787605E-2</c:v>
                </c:pt>
                <c:pt idx="11">
                  <c:v>7.8822003797609744E-2</c:v>
                </c:pt>
                <c:pt idx="12">
                  <c:v>8.0802189531303456E-2</c:v>
                </c:pt>
                <c:pt idx="13">
                  <c:v>0.11013832207207207</c:v>
                </c:pt>
                <c:pt idx="14">
                  <c:v>0.12064427498292737</c:v>
                </c:pt>
                <c:pt idx="15">
                  <c:v>9.8350112917795843E-2</c:v>
                </c:pt>
                <c:pt idx="16">
                  <c:v>0.11987210938386475</c:v>
                </c:pt>
                <c:pt idx="17">
                  <c:v>0.12609330762250454</c:v>
                </c:pt>
                <c:pt idx="18">
                  <c:v>0.15375961095764271</c:v>
                </c:pt>
                <c:pt idx="19">
                  <c:v>0.1695149461610487</c:v>
                </c:pt>
                <c:pt idx="20">
                  <c:v>0.13955945177434029</c:v>
                </c:pt>
                <c:pt idx="21">
                  <c:v>0.14066561715719825</c:v>
                </c:pt>
                <c:pt idx="22">
                  <c:v>7.6750119767309222E-2</c:v>
                </c:pt>
              </c:numCache>
            </c:numRef>
          </c:xVal>
          <c:yVal>
            <c:numRef>
              <c:f>(ASI!$I$37:$I$52,ASI!$I$54:$I$59,ASI!$I$61)</c:f>
              <c:numCache>
                <c:formatCode>General</c:formatCode>
                <c:ptCount val="23"/>
                <c:pt idx="0">
                  <c:v>4</c:v>
                </c:pt>
                <c:pt idx="1">
                  <c:v>5</c:v>
                </c:pt>
                <c:pt idx="2">
                  <c:v>3</c:v>
                </c:pt>
                <c:pt idx="3">
                  <c:v>5</c:v>
                </c:pt>
                <c:pt idx="4">
                  <c:v>4</c:v>
                </c:pt>
                <c:pt idx="5">
                  <c:v>4</c:v>
                </c:pt>
                <c:pt idx="6">
                  <c:v>3</c:v>
                </c:pt>
                <c:pt idx="7">
                  <c:v>3</c:v>
                </c:pt>
                <c:pt idx="8">
                  <c:v>4</c:v>
                </c:pt>
                <c:pt idx="9">
                  <c:v>5</c:v>
                </c:pt>
                <c:pt idx="10">
                  <c:v>3</c:v>
                </c:pt>
                <c:pt idx="11">
                  <c:v>5</c:v>
                </c:pt>
                <c:pt idx="12">
                  <c:v>7</c:v>
                </c:pt>
                <c:pt idx="13">
                  <c:v>3</c:v>
                </c:pt>
                <c:pt idx="14">
                  <c:v>3</c:v>
                </c:pt>
                <c:pt idx="15">
                  <c:v>4</c:v>
                </c:pt>
                <c:pt idx="16">
                  <c:v>2</c:v>
                </c:pt>
                <c:pt idx="17">
                  <c:v>3</c:v>
                </c:pt>
                <c:pt idx="18">
                  <c:v>1</c:v>
                </c:pt>
                <c:pt idx="19">
                  <c:v>3</c:v>
                </c:pt>
                <c:pt idx="20">
                  <c:v>3</c:v>
                </c:pt>
                <c:pt idx="21">
                  <c:v>4</c:v>
                </c:pt>
                <c:pt idx="22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693-49A4-884C-34F680F4564B}"/>
            </c:ext>
          </c:extLst>
        </c:ser>
        <c:ser>
          <c:idx val="0"/>
          <c:order val="3"/>
          <c:tx>
            <c:strRef>
              <c:f>ASI!$G$83</c:f>
              <c:strCache>
                <c:ptCount val="1"/>
                <c:pt idx="0">
                  <c:v>WCR+.ant+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4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  <a:effectLst/>
            </c:spPr>
          </c:marker>
          <c:xVal>
            <c:numRef>
              <c:f>(ASI!$H$83:$H$109,ASI!$H$111:$H$121)</c:f>
              <c:numCache>
                <c:formatCode>General</c:formatCode>
                <c:ptCount val="38"/>
                <c:pt idx="0">
                  <c:v>5.214198506331854E-2</c:v>
                </c:pt>
                <c:pt idx="1">
                  <c:v>6.8264184636118594E-2</c:v>
                </c:pt>
                <c:pt idx="2">
                  <c:v>7.0765983560409862E-2</c:v>
                </c:pt>
                <c:pt idx="3">
                  <c:v>9.3421057307863167E-2</c:v>
                </c:pt>
                <c:pt idx="4">
                  <c:v>9.2969834945930571E-2</c:v>
                </c:pt>
                <c:pt idx="5">
                  <c:v>8.64300474790866E-2</c:v>
                </c:pt>
                <c:pt idx="6">
                  <c:v>9.0536659784354212E-2</c:v>
                </c:pt>
                <c:pt idx="7">
                  <c:v>8.9187722132471725E-2</c:v>
                </c:pt>
                <c:pt idx="8">
                  <c:v>5.2628846758143923E-2</c:v>
                </c:pt>
                <c:pt idx="9">
                  <c:v>9.2910889655940326E-2</c:v>
                </c:pt>
                <c:pt idx="10">
                  <c:v>8.1230581882301076E-2</c:v>
                </c:pt>
                <c:pt idx="11">
                  <c:v>9.2074182969580462E-2</c:v>
                </c:pt>
                <c:pt idx="12">
                  <c:v>8.0408437779767236E-2</c:v>
                </c:pt>
                <c:pt idx="13">
                  <c:v>8.9699026819056241E-2</c:v>
                </c:pt>
                <c:pt idx="14">
                  <c:v>2.9540810002137211E-2</c:v>
                </c:pt>
                <c:pt idx="15">
                  <c:v>9.0340733634311512E-2</c:v>
                </c:pt>
                <c:pt idx="16">
                  <c:v>8.5173017873510531E-2</c:v>
                </c:pt>
                <c:pt idx="17">
                  <c:v>6.6241363483712082E-2</c:v>
                </c:pt>
                <c:pt idx="18">
                  <c:v>8.3327112434165324E-2</c:v>
                </c:pt>
                <c:pt idx="19">
                  <c:v>0.11459339309428952</c:v>
                </c:pt>
                <c:pt idx="20">
                  <c:v>0.12114365318176752</c:v>
                </c:pt>
                <c:pt idx="21">
                  <c:v>0.12666953990820554</c:v>
                </c:pt>
                <c:pt idx="22">
                  <c:v>0.10197073008849557</c:v>
                </c:pt>
                <c:pt idx="23">
                  <c:v>0.12188348987212855</c:v>
                </c:pt>
                <c:pt idx="24">
                  <c:v>0.10599086045982244</c:v>
                </c:pt>
                <c:pt idx="25">
                  <c:v>0.10908661898719577</c:v>
                </c:pt>
                <c:pt idx="26">
                  <c:v>0.11528761809492052</c:v>
                </c:pt>
                <c:pt idx="27">
                  <c:v>0.12312791889483067</c:v>
                </c:pt>
                <c:pt idx="28">
                  <c:v>0.11329880125476137</c:v>
                </c:pt>
                <c:pt idx="29">
                  <c:v>0.11283355764917004</c:v>
                </c:pt>
                <c:pt idx="30">
                  <c:v>0.1058522567475618</c:v>
                </c:pt>
                <c:pt idx="31">
                  <c:v>0.10058106891377121</c:v>
                </c:pt>
                <c:pt idx="32">
                  <c:v>0.13375609475620975</c:v>
                </c:pt>
                <c:pt idx="33">
                  <c:v>0.12910615208690682</c:v>
                </c:pt>
                <c:pt idx="34">
                  <c:v>0.14967950484643233</c:v>
                </c:pt>
                <c:pt idx="35">
                  <c:v>0.13768623344277142</c:v>
                </c:pt>
                <c:pt idx="36">
                  <c:v>0.13665410214929513</c:v>
                </c:pt>
                <c:pt idx="37">
                  <c:v>0.15499232997335188</c:v>
                </c:pt>
              </c:numCache>
            </c:numRef>
          </c:xVal>
          <c:yVal>
            <c:numRef>
              <c:f>(ASI!$I$83:$I$109,ASI!$I$111:$I$121)</c:f>
              <c:numCache>
                <c:formatCode>General</c:formatCode>
                <c:ptCount val="38"/>
                <c:pt idx="0">
                  <c:v>5</c:v>
                </c:pt>
                <c:pt idx="1">
                  <c:v>4</c:v>
                </c:pt>
                <c:pt idx="2">
                  <c:v>4</c:v>
                </c:pt>
                <c:pt idx="3">
                  <c:v>3</c:v>
                </c:pt>
                <c:pt idx="4">
                  <c:v>5</c:v>
                </c:pt>
                <c:pt idx="5">
                  <c:v>3</c:v>
                </c:pt>
                <c:pt idx="6">
                  <c:v>4</c:v>
                </c:pt>
                <c:pt idx="7">
                  <c:v>3</c:v>
                </c:pt>
                <c:pt idx="8">
                  <c:v>4</c:v>
                </c:pt>
                <c:pt idx="9">
                  <c:v>4</c:v>
                </c:pt>
                <c:pt idx="10">
                  <c:v>4</c:v>
                </c:pt>
                <c:pt idx="11">
                  <c:v>4</c:v>
                </c:pt>
                <c:pt idx="12">
                  <c:v>5</c:v>
                </c:pt>
                <c:pt idx="13">
                  <c:v>3</c:v>
                </c:pt>
                <c:pt idx="14">
                  <c:v>6</c:v>
                </c:pt>
                <c:pt idx="15">
                  <c:v>5</c:v>
                </c:pt>
                <c:pt idx="16">
                  <c:v>4</c:v>
                </c:pt>
                <c:pt idx="17">
                  <c:v>3</c:v>
                </c:pt>
                <c:pt idx="18">
                  <c:v>3</c:v>
                </c:pt>
                <c:pt idx="19">
                  <c:v>5</c:v>
                </c:pt>
                <c:pt idx="20">
                  <c:v>3</c:v>
                </c:pt>
                <c:pt idx="21">
                  <c:v>2</c:v>
                </c:pt>
                <c:pt idx="22">
                  <c:v>3</c:v>
                </c:pt>
                <c:pt idx="23">
                  <c:v>1</c:v>
                </c:pt>
                <c:pt idx="24">
                  <c:v>3</c:v>
                </c:pt>
                <c:pt idx="25">
                  <c:v>3</c:v>
                </c:pt>
                <c:pt idx="26">
                  <c:v>1</c:v>
                </c:pt>
                <c:pt idx="27">
                  <c:v>3</c:v>
                </c:pt>
                <c:pt idx="28">
                  <c:v>3</c:v>
                </c:pt>
                <c:pt idx="29">
                  <c:v>4</c:v>
                </c:pt>
                <c:pt idx="30">
                  <c:v>3</c:v>
                </c:pt>
                <c:pt idx="31">
                  <c:v>4</c:v>
                </c:pt>
                <c:pt idx="32">
                  <c:v>4</c:v>
                </c:pt>
                <c:pt idx="33">
                  <c:v>4</c:v>
                </c:pt>
                <c:pt idx="34">
                  <c:v>3</c:v>
                </c:pt>
                <c:pt idx="35">
                  <c:v>1</c:v>
                </c:pt>
                <c:pt idx="36">
                  <c:v>3</c:v>
                </c:pt>
                <c:pt idx="37">
                  <c:v>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4693-49A4-884C-34F680F4564B}"/>
            </c:ext>
          </c:extLst>
        </c:ser>
        <c:ser>
          <c:idx val="5"/>
          <c:order val="4"/>
          <c:tx>
            <c:v>all</c:v>
          </c:tx>
          <c:spPr>
            <a:ln w="19050">
              <a:noFill/>
            </a:ln>
          </c:spPr>
          <c:marker>
            <c:symbol val="none"/>
          </c:marker>
          <c:trendline>
            <c:spPr>
              <a:ln>
                <a:solidFill>
                  <a:schemeClr val="tx1"/>
                </a:solidFill>
              </a:ln>
            </c:spPr>
            <c:trendlineType val="linear"/>
            <c:dispRSqr val="0"/>
            <c:dispEq val="0"/>
          </c:trendline>
          <c:xVal>
            <c:numRef>
              <c:f>(ASI!$H$111:$H$121,ASI!$H$61:$H$109,ASI!$H$54:$H$59,ASI!$H$2:$H$52)</c:f>
              <c:numCache>
                <c:formatCode>General</c:formatCode>
                <c:ptCount val="117"/>
                <c:pt idx="0">
                  <c:v>0.12312791889483067</c:v>
                </c:pt>
                <c:pt idx="1">
                  <c:v>0.11329880125476137</c:v>
                </c:pt>
                <c:pt idx="2">
                  <c:v>0.11283355764917004</c:v>
                </c:pt>
                <c:pt idx="3">
                  <c:v>0.1058522567475618</c:v>
                </c:pt>
                <c:pt idx="4">
                  <c:v>0.10058106891377121</c:v>
                </c:pt>
                <c:pt idx="5">
                  <c:v>0.13375609475620975</c:v>
                </c:pt>
                <c:pt idx="6">
                  <c:v>0.12910615208690682</c:v>
                </c:pt>
                <c:pt idx="7">
                  <c:v>0.14967950484643233</c:v>
                </c:pt>
                <c:pt idx="8">
                  <c:v>0.13768623344277142</c:v>
                </c:pt>
                <c:pt idx="9">
                  <c:v>0.13665410214929513</c:v>
                </c:pt>
                <c:pt idx="10">
                  <c:v>0.15499232997335188</c:v>
                </c:pt>
                <c:pt idx="11">
                  <c:v>7.6750119767309222E-2</c:v>
                </c:pt>
                <c:pt idx="12">
                  <c:v>6.890087591240876E-2</c:v>
                </c:pt>
                <c:pt idx="13">
                  <c:v>5.9789072553805181E-2</c:v>
                </c:pt>
                <c:pt idx="14">
                  <c:v>6.8204656552886642E-2</c:v>
                </c:pt>
                <c:pt idx="15">
                  <c:v>3.5834822271154455E-2</c:v>
                </c:pt>
                <c:pt idx="16">
                  <c:v>9.3268444444444445E-2</c:v>
                </c:pt>
                <c:pt idx="17">
                  <c:v>9.695253948414953E-2</c:v>
                </c:pt>
                <c:pt idx="18">
                  <c:v>8.5442479469006641E-2</c:v>
                </c:pt>
                <c:pt idx="19">
                  <c:v>9.1108465363709951E-2</c:v>
                </c:pt>
                <c:pt idx="20">
                  <c:v>8.1050234258941839E-2</c:v>
                </c:pt>
                <c:pt idx="21">
                  <c:v>8.386411253430924E-2</c:v>
                </c:pt>
                <c:pt idx="22">
                  <c:v>6.1436159323542509E-2</c:v>
                </c:pt>
                <c:pt idx="23">
                  <c:v>0.11427219480092136</c:v>
                </c:pt>
                <c:pt idx="24">
                  <c:v>0.10828896413900299</c:v>
                </c:pt>
                <c:pt idx="25">
                  <c:v>0.11737765514134472</c:v>
                </c:pt>
                <c:pt idx="26">
                  <c:v>0.11935393700787403</c:v>
                </c:pt>
                <c:pt idx="27">
                  <c:v>0.11552079595123074</c:v>
                </c:pt>
                <c:pt idx="28">
                  <c:v>0.10443611865942029</c:v>
                </c:pt>
                <c:pt idx="29">
                  <c:v>0.17319410190786411</c:v>
                </c:pt>
                <c:pt idx="30">
                  <c:v>0.15940383631713556</c:v>
                </c:pt>
                <c:pt idx="31">
                  <c:v>0.13379139420831385</c:v>
                </c:pt>
                <c:pt idx="32">
                  <c:v>0.12934766729500471</c:v>
                </c:pt>
                <c:pt idx="33">
                  <c:v>5.214198506331854E-2</c:v>
                </c:pt>
                <c:pt idx="34">
                  <c:v>6.8264184636118594E-2</c:v>
                </c:pt>
                <c:pt idx="35">
                  <c:v>7.0765983560409862E-2</c:v>
                </c:pt>
                <c:pt idx="36">
                  <c:v>9.3421057307863167E-2</c:v>
                </c:pt>
                <c:pt idx="37">
                  <c:v>9.2969834945930571E-2</c:v>
                </c:pt>
                <c:pt idx="38">
                  <c:v>8.64300474790866E-2</c:v>
                </c:pt>
                <c:pt idx="39">
                  <c:v>9.0536659784354212E-2</c:v>
                </c:pt>
                <c:pt idx="40">
                  <c:v>8.9187722132471725E-2</c:v>
                </c:pt>
                <c:pt idx="41">
                  <c:v>5.2628846758143923E-2</c:v>
                </c:pt>
                <c:pt idx="42">
                  <c:v>9.2910889655940326E-2</c:v>
                </c:pt>
                <c:pt idx="43">
                  <c:v>8.1230581882301076E-2</c:v>
                </c:pt>
                <c:pt idx="44">
                  <c:v>9.2074182969580462E-2</c:v>
                </c:pt>
                <c:pt idx="45">
                  <c:v>8.0408437779767236E-2</c:v>
                </c:pt>
                <c:pt idx="46">
                  <c:v>8.9699026819056241E-2</c:v>
                </c:pt>
                <c:pt idx="47">
                  <c:v>2.9540810002137211E-2</c:v>
                </c:pt>
                <c:pt idx="48">
                  <c:v>9.0340733634311512E-2</c:v>
                </c:pt>
                <c:pt idx="49">
                  <c:v>8.5173017873510531E-2</c:v>
                </c:pt>
                <c:pt idx="50">
                  <c:v>6.6241363483712082E-2</c:v>
                </c:pt>
                <c:pt idx="51">
                  <c:v>8.3327112434165324E-2</c:v>
                </c:pt>
                <c:pt idx="52">
                  <c:v>0.11459339309428952</c:v>
                </c:pt>
                <c:pt idx="53">
                  <c:v>0.12114365318176752</c:v>
                </c:pt>
                <c:pt idx="54">
                  <c:v>0.12666953990820554</c:v>
                </c:pt>
                <c:pt idx="55">
                  <c:v>0.10197073008849557</c:v>
                </c:pt>
                <c:pt idx="56">
                  <c:v>0.12188348987212855</c:v>
                </c:pt>
                <c:pt idx="57">
                  <c:v>0.10599086045982244</c:v>
                </c:pt>
                <c:pt idx="58">
                  <c:v>0.10908661898719577</c:v>
                </c:pt>
                <c:pt idx="59">
                  <c:v>0.11528761809492052</c:v>
                </c:pt>
                <c:pt idx="60">
                  <c:v>0.11987210938386475</c:v>
                </c:pt>
                <c:pt idx="61">
                  <c:v>0.12609330762250454</c:v>
                </c:pt>
                <c:pt idx="62">
                  <c:v>0.15375961095764271</c:v>
                </c:pt>
                <c:pt idx="63">
                  <c:v>0.1695149461610487</c:v>
                </c:pt>
                <c:pt idx="64">
                  <c:v>0.13955945177434029</c:v>
                </c:pt>
                <c:pt idx="65">
                  <c:v>0.14066561715719825</c:v>
                </c:pt>
                <c:pt idx="66">
                  <c:v>7.5780074889367971E-2</c:v>
                </c:pt>
                <c:pt idx="67">
                  <c:v>4.9145514483354948E-2</c:v>
                </c:pt>
                <c:pt idx="68">
                  <c:v>7.6867708925525871E-2</c:v>
                </c:pt>
                <c:pt idx="69">
                  <c:v>7.4774765933446133E-2</c:v>
                </c:pt>
                <c:pt idx="70">
                  <c:v>7.0503379520108156E-2</c:v>
                </c:pt>
                <c:pt idx="71">
                  <c:v>9.4409345289541924E-2</c:v>
                </c:pt>
                <c:pt idx="72">
                  <c:v>9.7477298753789146E-2</c:v>
                </c:pt>
                <c:pt idx="73">
                  <c:v>8.7058931331419731E-2</c:v>
                </c:pt>
                <c:pt idx="74">
                  <c:v>8.7912219820229828E-2</c:v>
                </c:pt>
                <c:pt idx="75">
                  <c:v>8.9650907042253522E-2</c:v>
                </c:pt>
                <c:pt idx="76">
                  <c:v>7.9004195023987506E-2</c:v>
                </c:pt>
                <c:pt idx="77">
                  <c:v>8.2006408789196614E-2</c:v>
                </c:pt>
                <c:pt idx="78">
                  <c:v>8.3962924582613715E-2</c:v>
                </c:pt>
                <c:pt idx="79">
                  <c:v>8.1276690188936948E-2</c:v>
                </c:pt>
                <c:pt idx="80">
                  <c:v>9.5693162586031819E-2</c:v>
                </c:pt>
                <c:pt idx="81">
                  <c:v>9.588310258738085E-2</c:v>
                </c:pt>
                <c:pt idx="82">
                  <c:v>9.3093649694030722E-2</c:v>
                </c:pt>
                <c:pt idx="83">
                  <c:v>0.12461974649766511</c:v>
                </c:pt>
                <c:pt idx="84">
                  <c:v>0.12507408042037926</c:v>
                </c:pt>
                <c:pt idx="85">
                  <c:v>0.11005851533325789</c:v>
                </c:pt>
                <c:pt idx="86">
                  <c:v>0.10377092765201953</c:v>
                </c:pt>
                <c:pt idx="87">
                  <c:v>0.11311291243292614</c:v>
                </c:pt>
                <c:pt idx="88">
                  <c:v>0.10599187840290382</c:v>
                </c:pt>
                <c:pt idx="89">
                  <c:v>0.12067237982195846</c:v>
                </c:pt>
                <c:pt idx="90">
                  <c:v>0.10589079794782229</c:v>
                </c:pt>
                <c:pt idx="91">
                  <c:v>0.12148469444754775</c:v>
                </c:pt>
                <c:pt idx="92">
                  <c:v>0.10590549510935267</c:v>
                </c:pt>
                <c:pt idx="93">
                  <c:v>0.1152442808219178</c:v>
                </c:pt>
                <c:pt idx="94">
                  <c:v>0.10901318269558305</c:v>
                </c:pt>
                <c:pt idx="95">
                  <c:v>0.11288567536889897</c:v>
                </c:pt>
                <c:pt idx="96">
                  <c:v>0.10836070482552113</c:v>
                </c:pt>
                <c:pt idx="97">
                  <c:v>0.14498016868019148</c:v>
                </c:pt>
                <c:pt idx="98">
                  <c:v>0.12752769931662872</c:v>
                </c:pt>
                <c:pt idx="99">
                  <c:v>0.13532261113055655</c:v>
                </c:pt>
                <c:pt idx="100">
                  <c:v>0.1875099204492279</c:v>
                </c:pt>
                <c:pt idx="101">
                  <c:v>7.9080140313005934E-2</c:v>
                </c:pt>
                <c:pt idx="102">
                  <c:v>7.7779019104010735E-2</c:v>
                </c:pt>
                <c:pt idx="103">
                  <c:v>9.9053037713292033E-2</c:v>
                </c:pt>
                <c:pt idx="104">
                  <c:v>9.6959645131938124E-2</c:v>
                </c:pt>
                <c:pt idx="105">
                  <c:v>9.3015060240963857E-2</c:v>
                </c:pt>
                <c:pt idx="106">
                  <c:v>8.8794142921754859E-2</c:v>
                </c:pt>
                <c:pt idx="107">
                  <c:v>8.7514529816513767E-2</c:v>
                </c:pt>
                <c:pt idx="108">
                  <c:v>9.2192299181234796E-2</c:v>
                </c:pt>
                <c:pt idx="109">
                  <c:v>9.0149678206835324E-2</c:v>
                </c:pt>
                <c:pt idx="110">
                  <c:v>8.7568655229662423E-2</c:v>
                </c:pt>
                <c:pt idx="111">
                  <c:v>9.6900160734787605E-2</c:v>
                </c:pt>
                <c:pt idx="112">
                  <c:v>7.8822003797609744E-2</c:v>
                </c:pt>
                <c:pt idx="113">
                  <c:v>8.0802189531303456E-2</c:v>
                </c:pt>
                <c:pt idx="114">
                  <c:v>0.11013832207207207</c:v>
                </c:pt>
                <c:pt idx="115">
                  <c:v>0.12064427498292737</c:v>
                </c:pt>
                <c:pt idx="116">
                  <c:v>9.8350112917795843E-2</c:v>
                </c:pt>
              </c:numCache>
            </c:numRef>
          </c:xVal>
          <c:yVal>
            <c:numRef>
              <c:f>(ASI!$I$111:$I$121,ASI!$I$61:$I$109,ASI!$I$54:$I$59,ASI!$I$2:$I$52)</c:f>
              <c:numCache>
                <c:formatCode>General</c:formatCode>
                <c:ptCount val="117"/>
                <c:pt idx="0">
                  <c:v>3</c:v>
                </c:pt>
                <c:pt idx="1">
                  <c:v>3</c:v>
                </c:pt>
                <c:pt idx="2">
                  <c:v>4</c:v>
                </c:pt>
                <c:pt idx="3">
                  <c:v>3</c:v>
                </c:pt>
                <c:pt idx="4">
                  <c:v>4</c:v>
                </c:pt>
                <c:pt idx="5">
                  <c:v>4</c:v>
                </c:pt>
                <c:pt idx="6">
                  <c:v>4</c:v>
                </c:pt>
                <c:pt idx="7">
                  <c:v>3</c:v>
                </c:pt>
                <c:pt idx="8">
                  <c:v>1</c:v>
                </c:pt>
                <c:pt idx="9">
                  <c:v>3</c:v>
                </c:pt>
                <c:pt idx="10">
                  <c:v>3</c:v>
                </c:pt>
                <c:pt idx="11">
                  <c:v>1</c:v>
                </c:pt>
                <c:pt idx="12">
                  <c:v>5</c:v>
                </c:pt>
                <c:pt idx="13">
                  <c:v>5</c:v>
                </c:pt>
                <c:pt idx="14">
                  <c:v>7</c:v>
                </c:pt>
                <c:pt idx="15">
                  <c:v>3</c:v>
                </c:pt>
                <c:pt idx="16">
                  <c:v>4</c:v>
                </c:pt>
                <c:pt idx="17">
                  <c:v>5</c:v>
                </c:pt>
                <c:pt idx="18">
                  <c:v>4</c:v>
                </c:pt>
                <c:pt idx="19">
                  <c:v>1</c:v>
                </c:pt>
                <c:pt idx="20">
                  <c:v>4</c:v>
                </c:pt>
                <c:pt idx="21">
                  <c:v>4</c:v>
                </c:pt>
                <c:pt idx="22">
                  <c:v>4</c:v>
                </c:pt>
                <c:pt idx="23">
                  <c:v>4</c:v>
                </c:pt>
                <c:pt idx="24">
                  <c:v>3</c:v>
                </c:pt>
                <c:pt idx="25">
                  <c:v>4</c:v>
                </c:pt>
                <c:pt idx="26">
                  <c:v>3</c:v>
                </c:pt>
                <c:pt idx="27">
                  <c:v>2</c:v>
                </c:pt>
                <c:pt idx="28">
                  <c:v>4</c:v>
                </c:pt>
                <c:pt idx="29">
                  <c:v>1</c:v>
                </c:pt>
                <c:pt idx="30">
                  <c:v>1</c:v>
                </c:pt>
                <c:pt idx="31">
                  <c:v>0</c:v>
                </c:pt>
                <c:pt idx="32">
                  <c:v>3</c:v>
                </c:pt>
                <c:pt idx="33">
                  <c:v>5</c:v>
                </c:pt>
                <c:pt idx="34">
                  <c:v>4</c:v>
                </c:pt>
                <c:pt idx="35">
                  <c:v>4</c:v>
                </c:pt>
                <c:pt idx="36">
                  <c:v>3</c:v>
                </c:pt>
                <c:pt idx="37">
                  <c:v>5</c:v>
                </c:pt>
                <c:pt idx="38">
                  <c:v>3</c:v>
                </c:pt>
                <c:pt idx="39">
                  <c:v>4</c:v>
                </c:pt>
                <c:pt idx="40">
                  <c:v>3</c:v>
                </c:pt>
                <c:pt idx="41">
                  <c:v>4</c:v>
                </c:pt>
                <c:pt idx="42">
                  <c:v>4</c:v>
                </c:pt>
                <c:pt idx="43">
                  <c:v>4</c:v>
                </c:pt>
                <c:pt idx="44">
                  <c:v>4</c:v>
                </c:pt>
                <c:pt idx="45">
                  <c:v>5</c:v>
                </c:pt>
                <c:pt idx="46">
                  <c:v>3</c:v>
                </c:pt>
                <c:pt idx="47">
                  <c:v>6</c:v>
                </c:pt>
                <c:pt idx="48">
                  <c:v>5</c:v>
                </c:pt>
                <c:pt idx="49">
                  <c:v>4</c:v>
                </c:pt>
                <c:pt idx="50">
                  <c:v>3</c:v>
                </c:pt>
                <c:pt idx="51">
                  <c:v>3</c:v>
                </c:pt>
                <c:pt idx="52">
                  <c:v>5</c:v>
                </c:pt>
                <c:pt idx="53">
                  <c:v>3</c:v>
                </c:pt>
                <c:pt idx="54">
                  <c:v>2</c:v>
                </c:pt>
                <c:pt idx="55">
                  <c:v>3</c:v>
                </c:pt>
                <c:pt idx="56">
                  <c:v>1</c:v>
                </c:pt>
                <c:pt idx="57">
                  <c:v>3</c:v>
                </c:pt>
                <c:pt idx="58">
                  <c:v>3</c:v>
                </c:pt>
                <c:pt idx="59">
                  <c:v>1</c:v>
                </c:pt>
                <c:pt idx="60">
                  <c:v>2</c:v>
                </c:pt>
                <c:pt idx="61">
                  <c:v>3</c:v>
                </c:pt>
                <c:pt idx="62">
                  <c:v>1</c:v>
                </c:pt>
                <c:pt idx="63">
                  <c:v>3</c:v>
                </c:pt>
                <c:pt idx="64">
                  <c:v>3</c:v>
                </c:pt>
                <c:pt idx="65">
                  <c:v>4</c:v>
                </c:pt>
                <c:pt idx="66">
                  <c:v>3</c:v>
                </c:pt>
                <c:pt idx="67">
                  <c:v>3</c:v>
                </c:pt>
                <c:pt idx="68">
                  <c:v>4</c:v>
                </c:pt>
                <c:pt idx="69">
                  <c:v>5</c:v>
                </c:pt>
                <c:pt idx="70">
                  <c:v>4</c:v>
                </c:pt>
                <c:pt idx="71">
                  <c:v>4</c:v>
                </c:pt>
                <c:pt idx="72">
                  <c:v>4</c:v>
                </c:pt>
                <c:pt idx="73">
                  <c:v>3</c:v>
                </c:pt>
                <c:pt idx="74">
                  <c:v>3</c:v>
                </c:pt>
                <c:pt idx="75">
                  <c:v>3</c:v>
                </c:pt>
                <c:pt idx="76">
                  <c:v>5</c:v>
                </c:pt>
                <c:pt idx="77">
                  <c:v>3</c:v>
                </c:pt>
                <c:pt idx="78">
                  <c:v>0</c:v>
                </c:pt>
                <c:pt idx="79">
                  <c:v>5</c:v>
                </c:pt>
                <c:pt idx="80">
                  <c:v>3</c:v>
                </c:pt>
                <c:pt idx="81">
                  <c:v>4</c:v>
                </c:pt>
                <c:pt idx="82">
                  <c:v>2</c:v>
                </c:pt>
                <c:pt idx="83">
                  <c:v>3</c:v>
                </c:pt>
                <c:pt idx="84">
                  <c:v>0</c:v>
                </c:pt>
                <c:pt idx="85">
                  <c:v>3</c:v>
                </c:pt>
                <c:pt idx="86">
                  <c:v>4</c:v>
                </c:pt>
                <c:pt idx="87">
                  <c:v>1</c:v>
                </c:pt>
                <c:pt idx="88">
                  <c:v>4</c:v>
                </c:pt>
                <c:pt idx="89">
                  <c:v>4</c:v>
                </c:pt>
                <c:pt idx="90">
                  <c:v>4</c:v>
                </c:pt>
                <c:pt idx="91">
                  <c:v>4</c:v>
                </c:pt>
                <c:pt idx="92">
                  <c:v>3</c:v>
                </c:pt>
                <c:pt idx="93">
                  <c:v>0</c:v>
                </c:pt>
                <c:pt idx="94">
                  <c:v>1</c:v>
                </c:pt>
                <c:pt idx="95">
                  <c:v>2</c:v>
                </c:pt>
                <c:pt idx="96">
                  <c:v>4</c:v>
                </c:pt>
                <c:pt idx="97">
                  <c:v>1</c:v>
                </c:pt>
                <c:pt idx="98">
                  <c:v>3</c:v>
                </c:pt>
                <c:pt idx="99">
                  <c:v>4</c:v>
                </c:pt>
                <c:pt idx="100">
                  <c:v>2</c:v>
                </c:pt>
                <c:pt idx="101">
                  <c:v>4</c:v>
                </c:pt>
                <c:pt idx="102">
                  <c:v>5</c:v>
                </c:pt>
                <c:pt idx="103">
                  <c:v>3</c:v>
                </c:pt>
                <c:pt idx="104">
                  <c:v>5</c:v>
                </c:pt>
                <c:pt idx="105">
                  <c:v>4</c:v>
                </c:pt>
                <c:pt idx="106">
                  <c:v>4</c:v>
                </c:pt>
                <c:pt idx="107">
                  <c:v>3</c:v>
                </c:pt>
                <c:pt idx="108">
                  <c:v>3</c:v>
                </c:pt>
                <c:pt idx="109">
                  <c:v>4</c:v>
                </c:pt>
                <c:pt idx="110">
                  <c:v>5</c:v>
                </c:pt>
                <c:pt idx="111">
                  <c:v>3</c:v>
                </c:pt>
                <c:pt idx="112">
                  <c:v>5</c:v>
                </c:pt>
                <c:pt idx="113">
                  <c:v>7</c:v>
                </c:pt>
                <c:pt idx="114">
                  <c:v>3</c:v>
                </c:pt>
                <c:pt idx="115">
                  <c:v>3</c:v>
                </c:pt>
                <c:pt idx="116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4693-49A4-884C-34F680F456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4920080"/>
        <c:axId val="514920408"/>
      </c:scatterChart>
      <c:valAx>
        <c:axId val="514920080"/>
        <c:scaling>
          <c:orientation val="minMax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en-US" sz="1000" b="0" i="0" u="none" strike="noStrike" baseline="0" dirty="0">
                    <a:effectLst/>
                  </a:rPr>
                  <a:t>Soil water content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%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514920408"/>
        <c:crosses val="autoZero"/>
        <c:crossBetween val="midCat"/>
        <c:majorUnit val="5.000000000000001E-2"/>
      </c:valAx>
      <c:valAx>
        <c:axId val="51492040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ASI (days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514920080"/>
        <c:crosses val="autoZero"/>
        <c:crossBetween val="midCat"/>
        <c:majorUnit val="2"/>
      </c:valAx>
      <c:spPr>
        <a:ln>
          <a:noFill/>
        </a:ln>
      </c:spPr>
    </c:plotArea>
    <c:plotVisOnly val="1"/>
    <c:dispBlanksAs val="gap"/>
    <c:showDLblsOverMax val="0"/>
  </c:chart>
  <c:txPr>
    <a:bodyPr/>
    <a:lstStyle/>
    <a:p>
      <a:pPr>
        <a:defRPr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  <c:userShapes r:id="rId3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8839</cdr:x>
      <cdr:y>0.01512</cdr:y>
    </cdr:from>
    <cdr:to>
      <cdr:x>0.72227</cdr:x>
      <cdr:y>0.10061</cdr:y>
    </cdr:to>
    <cdr:sp macro="" textlink="">
      <cdr:nvSpPr>
        <cdr:cNvPr id="5" name="TextBox 11"/>
        <cdr:cNvSpPr txBox="1"/>
      </cdr:nvSpPr>
      <cdr:spPr>
        <a:xfrm xmlns:a="http://schemas.openxmlformats.org/drawingml/2006/main">
          <a:off x="1406558" y="43537"/>
          <a:ext cx="673582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 anchor="ctr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p = 0.819</a:t>
          </a:r>
        </a:p>
      </cdr:txBody>
    </cdr:sp>
  </cdr:relSizeAnchor>
  <cdr:relSizeAnchor xmlns:cdr="http://schemas.openxmlformats.org/drawingml/2006/chartDrawing">
    <cdr:from>
      <cdr:x>0.41468</cdr:x>
      <cdr:y>0.09198</cdr:y>
    </cdr:from>
    <cdr:to>
      <cdr:x>0.79597</cdr:x>
      <cdr:y>0.10449</cdr:y>
    </cdr:to>
    <cdr:grpSp>
      <cdr:nvGrpSpPr>
        <cdr:cNvPr id="7" name="Group 6">
          <a:extLst xmlns:a="http://schemas.openxmlformats.org/drawingml/2006/main">
            <a:ext uri="{FF2B5EF4-FFF2-40B4-BE49-F238E27FC236}">
              <a16:creationId xmlns:a16="http://schemas.microsoft.com/office/drawing/2014/main" id="{A271E2A5-277C-4437-85E2-9AED5D638F20}"/>
            </a:ext>
          </a:extLst>
        </cdr:cNvPr>
        <cdr:cNvGrpSpPr/>
      </cdr:nvGrpSpPr>
      <cdr:grpSpPr>
        <a:xfrm xmlns:a="http://schemas.openxmlformats.org/drawingml/2006/main">
          <a:off x="1194278" y="264902"/>
          <a:ext cx="1098116" cy="36029"/>
          <a:chOff x="1563647" y="1127640"/>
          <a:chExt cx="1098000" cy="36000"/>
        </a:xfrm>
      </cdr:grpSpPr>
      <cdr:cxnSp macro="">
        <cdr:nvCxnSpPr>
          <cdr:cNvPr id="8" name="Straight Connector 7">
            <a:extLst xmlns:a="http://schemas.openxmlformats.org/drawingml/2006/main">
              <a:ext uri="{FF2B5EF4-FFF2-40B4-BE49-F238E27FC236}">
                <a16:creationId xmlns:a16="http://schemas.microsoft.com/office/drawing/2014/main" id="{81367370-1FD3-4C70-8657-534D9123546A}"/>
              </a:ext>
            </a:extLst>
          </cdr:cNvPr>
          <cdr:cNvCxnSpPr/>
        </cdr:nvCxnSpPr>
        <cdr:spPr>
          <a:xfrm xmlns:a="http://schemas.openxmlformats.org/drawingml/2006/main">
            <a:off x="1563647" y="1127640"/>
            <a:ext cx="1098000" cy="0"/>
          </a:xfrm>
          <a:prstGeom xmlns:a="http://schemas.openxmlformats.org/drawingml/2006/main" prst="line">
            <a:avLst/>
          </a:prstGeom>
          <a:ln xmlns:a="http://schemas.openxmlformats.org/drawingml/2006/main" w="9525"/>
        </cdr:spPr>
        <cdr:style>
          <a:lnRef xmlns:a="http://schemas.openxmlformats.org/drawingml/2006/main" idx="1">
            <a:schemeClr val="dk1"/>
          </a:lnRef>
          <a:fillRef xmlns:a="http://schemas.openxmlformats.org/drawingml/2006/main" idx="0">
            <a:schemeClr val="dk1"/>
          </a:fillRef>
          <a:effectRef xmlns:a="http://schemas.openxmlformats.org/drawingml/2006/main" idx="0">
            <a:schemeClr val="dk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9" name="Straight Connector 8">
            <a:extLst xmlns:a="http://schemas.openxmlformats.org/drawingml/2006/main">
              <a:ext uri="{FF2B5EF4-FFF2-40B4-BE49-F238E27FC236}">
                <a16:creationId xmlns:a16="http://schemas.microsoft.com/office/drawing/2014/main" id="{4DFC5A4B-48AE-4596-B9B7-E7B74C1FC41B}"/>
              </a:ext>
            </a:extLst>
          </cdr:cNvPr>
          <cdr:cNvCxnSpPr/>
        </cdr:nvCxnSpPr>
        <cdr:spPr>
          <a:xfrm xmlns:a="http://schemas.openxmlformats.org/drawingml/2006/main" rot="5400000">
            <a:off x="1550409" y="1145640"/>
            <a:ext cx="36000" cy="0"/>
          </a:xfrm>
          <a:prstGeom xmlns:a="http://schemas.openxmlformats.org/drawingml/2006/main" prst="line">
            <a:avLst/>
          </a:prstGeom>
          <a:ln xmlns:a="http://schemas.openxmlformats.org/drawingml/2006/main" w="9525"/>
        </cdr:spPr>
        <cdr:style>
          <a:lnRef xmlns:a="http://schemas.openxmlformats.org/drawingml/2006/main" idx="1">
            <a:schemeClr val="dk1"/>
          </a:lnRef>
          <a:fillRef xmlns:a="http://schemas.openxmlformats.org/drawingml/2006/main" idx="0">
            <a:schemeClr val="dk1"/>
          </a:fillRef>
          <a:effectRef xmlns:a="http://schemas.openxmlformats.org/drawingml/2006/main" idx="0">
            <a:schemeClr val="dk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0" name="Straight Connector 9">
            <a:extLst xmlns:a="http://schemas.openxmlformats.org/drawingml/2006/main">
              <a:ext uri="{FF2B5EF4-FFF2-40B4-BE49-F238E27FC236}">
                <a16:creationId xmlns:a16="http://schemas.microsoft.com/office/drawing/2014/main" id="{9535D9BA-5B48-4C0E-9D8E-7115C6CED011}"/>
              </a:ext>
            </a:extLst>
          </cdr:cNvPr>
          <cdr:cNvCxnSpPr/>
        </cdr:nvCxnSpPr>
        <cdr:spPr>
          <a:xfrm xmlns:a="http://schemas.openxmlformats.org/drawingml/2006/main" rot="5400000">
            <a:off x="2638885" y="1145640"/>
            <a:ext cx="36000" cy="0"/>
          </a:xfrm>
          <a:prstGeom xmlns:a="http://schemas.openxmlformats.org/drawingml/2006/main" prst="line">
            <a:avLst/>
          </a:prstGeom>
          <a:ln xmlns:a="http://schemas.openxmlformats.org/drawingml/2006/main" w="9525"/>
        </cdr:spPr>
        <cdr:style>
          <a:lnRef xmlns:a="http://schemas.openxmlformats.org/drawingml/2006/main" idx="1">
            <a:schemeClr val="dk1"/>
          </a:lnRef>
          <a:fillRef xmlns:a="http://schemas.openxmlformats.org/drawingml/2006/main" idx="0">
            <a:schemeClr val="dk1"/>
          </a:fillRef>
          <a:effectRef xmlns:a="http://schemas.openxmlformats.org/drawingml/2006/main" idx="0">
            <a:schemeClr val="dk1"/>
          </a:effectRef>
          <a:fontRef xmlns:a="http://schemas.openxmlformats.org/drawingml/2006/main" idx="minor">
            <a:schemeClr val="tx1"/>
          </a:fontRef>
        </cdr:style>
      </cdr:cxnSp>
    </cdr:grp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3896</cdr:x>
      <cdr:y>0.08949</cdr:y>
    </cdr:from>
    <cdr:to>
      <cdr:x>0.26596</cdr:x>
      <cdr:y>0.3011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000526" y="386603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14427</cdr:x>
      <cdr:y>0.0488</cdr:y>
    </cdr:from>
    <cdr:to>
      <cdr:x>0.27623</cdr:x>
      <cdr:y>0.2091</cdr:y>
    </cdr:to>
    <cdr:sp macro="" textlink="">
      <cdr:nvSpPr>
        <cdr:cNvPr id="3" name="TextBox 6">
          <a:extLst xmlns:a="http://schemas.openxmlformats.org/drawingml/2006/main">
            <a:ext uri="{FF2B5EF4-FFF2-40B4-BE49-F238E27FC236}">
              <a16:creationId xmlns:a16="http://schemas.microsoft.com/office/drawing/2014/main" id="{F048C244-9964-4037-B782-4A0E3B4C2128}"/>
            </a:ext>
          </a:extLst>
        </cdr:cNvPr>
        <cdr:cNvSpPr txBox="1"/>
      </cdr:nvSpPr>
      <cdr:spPr>
        <a:xfrm xmlns:a="http://schemas.openxmlformats.org/drawingml/2006/main">
          <a:off x="853848" y="140544"/>
          <a:ext cx="780983" cy="46166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l" rtl="0">
            <a:tabLst>
              <a:tab pos="361950" algn="l"/>
              <a:tab pos="717550" algn="l"/>
            </a:tabLst>
          </a:pPr>
          <a:r>
            <a:rPr lang="en-US" sz="800" kern="1200" dirty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H2O	</a:t>
          </a:r>
          <a:r>
            <a:rPr lang="en-US" sz="8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0.120</a:t>
          </a:r>
        </a:p>
        <a:p xmlns:a="http://schemas.openxmlformats.org/drawingml/2006/main">
          <a:pPr algn="l" rtl="0">
            <a:tabLst>
              <a:tab pos="361950" algn="l"/>
              <a:tab pos="717550" algn="l"/>
            </a:tabLst>
          </a:pPr>
          <a:r>
            <a:rPr lang="en-US" sz="800" kern="1200" dirty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WCR	</a:t>
          </a:r>
          <a:r>
            <a:rPr lang="en-US" sz="8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0.602</a:t>
          </a:r>
          <a:endParaRPr lang="en-US" sz="800" kern="1200" dirty="0">
            <a:solidFill>
              <a:schemeClr val="tx1"/>
            </a:solidFill>
            <a:latin typeface="Times New Roman" panose="02020603050405020304" pitchFamily="18" charset="0"/>
            <a:ea typeface="+mn-ea"/>
            <a:cs typeface="Times New Roman" panose="02020603050405020304" pitchFamily="18" charset="0"/>
          </a:endParaRPr>
        </a:p>
        <a:p xmlns:a="http://schemas.openxmlformats.org/drawingml/2006/main">
          <a:pPr algn="l" rtl="0">
            <a:tabLst>
              <a:tab pos="361950" algn="l"/>
              <a:tab pos="717550" algn="l"/>
            </a:tabLst>
          </a:pPr>
          <a:r>
            <a:rPr lang="en-US" sz="800" kern="1200" dirty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ants	</a:t>
          </a:r>
          <a:r>
            <a:rPr lang="en-US" sz="8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0.176</a:t>
          </a:r>
          <a:endParaRPr lang="en-US" sz="800" kern="1200" dirty="0">
            <a:solidFill>
              <a:schemeClr val="tx1"/>
            </a:solidFill>
            <a:latin typeface="Times New Roman" panose="02020603050405020304" pitchFamily="18" charset="0"/>
            <a:ea typeface="+mn-ea"/>
            <a:cs typeface="Times New Roman" panose="02020603050405020304" pitchFamily="18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09082</cdr:x>
      <cdr:y>0.6405</cdr:y>
    </cdr:from>
    <cdr:to>
      <cdr:x>0.27023</cdr:x>
      <cdr:y>0.80073</cdr:y>
    </cdr:to>
    <cdr:sp macro="" textlink="">
      <cdr:nvSpPr>
        <cdr:cNvPr id="3" name="TextBox 6"/>
        <cdr:cNvSpPr txBox="1"/>
      </cdr:nvSpPr>
      <cdr:spPr>
        <a:xfrm xmlns:a="http://schemas.openxmlformats.org/drawingml/2006/main">
          <a:off x="537487" y="1845487"/>
          <a:ext cx="1061829" cy="46166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>
            <a:tabLst>
              <a:tab pos="358775" algn="l"/>
              <a:tab pos="715963" algn="l"/>
            </a:tabLst>
          </a:pPr>
          <a:r>
            <a:rPr lang="en-US" sz="8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H</a:t>
          </a:r>
          <a:r>
            <a:rPr lang="en-US" sz="800" baseline="-25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2</a:t>
          </a:r>
          <a:r>
            <a:rPr lang="en-US" sz="8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O 	&lt;0.001	***</a:t>
          </a:r>
        </a:p>
        <a:p xmlns:a="http://schemas.openxmlformats.org/drawingml/2006/main">
          <a:pPr>
            <a:tabLst>
              <a:tab pos="358775" algn="l"/>
              <a:tab pos="715963" algn="l"/>
            </a:tabLst>
          </a:pPr>
          <a:r>
            <a:rPr lang="en-US" sz="8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WCR	0.695</a:t>
          </a:r>
        </a:p>
        <a:p xmlns:a="http://schemas.openxmlformats.org/drawingml/2006/main">
          <a:pPr>
            <a:tabLst>
              <a:tab pos="358775" algn="l"/>
              <a:tab pos="715963" algn="l"/>
            </a:tabLst>
          </a:pPr>
          <a:r>
            <a:rPr lang="en-US" sz="8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ants	0.119</a:t>
          </a:r>
        </a:p>
      </cdr:txBody>
    </cdr:sp>
  </cdr:relSizeAnchor>
  <cdr:relSizeAnchor xmlns:cdr="http://schemas.openxmlformats.org/drawingml/2006/chartDrawing">
    <cdr:from>
      <cdr:x>0.25506</cdr:x>
      <cdr:y>0.21647</cdr:y>
    </cdr:from>
    <cdr:to>
      <cdr:x>0.36047</cdr:x>
      <cdr:y>0.29124</cdr:y>
    </cdr:to>
    <cdr:sp macro="" textlink="">
      <cdr:nvSpPr>
        <cdr:cNvPr id="4" name="TextBox 4"/>
        <cdr:cNvSpPr txBox="1"/>
      </cdr:nvSpPr>
      <cdr:spPr>
        <a:xfrm xmlns:a="http://schemas.openxmlformats.org/drawingml/2006/main">
          <a:off x="1509522" y="623717"/>
          <a:ext cx="623892" cy="215436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 anchor="ctr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>
            <a:defRPr sz="600" b="0" i="0" u="none" strike="noStrike" kern="1200" baseline="0">
              <a:solidFill>
                <a:prstClr val="black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r>
            <a:rPr lang="en-US" sz="800" dirty="0">
              <a:latin typeface="Times New Roman" panose="02020603050405020304" pitchFamily="18" charset="0"/>
              <a:cs typeface="Times New Roman" panose="02020603050405020304" pitchFamily="18" charset="0"/>
            </a:rPr>
            <a:t>R² = </a:t>
          </a:r>
          <a:r>
            <a:rPr lang="en-US" sz="800" dirty="0"/>
            <a:t>0.230</a:t>
          </a:r>
          <a:endParaRPr lang="en-US" sz="8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621696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7C1BF76-36A5-4BE1-9F9A-9A595CD42765}" type="datetimeFigureOut">
              <a:rPr lang="en-US" smtClean="0"/>
              <a:t>3/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45741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621696" y="645741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B5BB22-DB61-49B6-BF71-73A35A3094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06634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2799" y="0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CA353C-2836-4824-8D04-B9B1F86AE316}" type="datetimeFigureOut">
              <a:rPr lang="en-US" smtClean="0"/>
              <a:t>3/7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70363" y="850900"/>
            <a:ext cx="1585912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2665" y="3271381"/>
            <a:ext cx="7941310" cy="267658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45661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2799" y="645661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EE1906-8236-475E-AE3B-714008C6E8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24358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baseline="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EE1906-8236-475E-AE3B-714008C6E84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89937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EE1906-8236-475E-AE3B-714008C6E84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8369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EE1906-8236-475E-AE3B-714008C6E84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0040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EE1906-8236-475E-AE3B-714008C6E849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53623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EE1906-8236-475E-AE3B-714008C6E849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1643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8FBC-9304-449D-ACA2-13D6F5143335}" type="datetimeFigureOut">
              <a:rPr lang="en-US" smtClean="0"/>
              <a:t>3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70AFF-06FA-4B29-8ED9-C4D672D5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6438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8FBC-9304-449D-ACA2-13D6F5143335}" type="datetimeFigureOut">
              <a:rPr lang="en-US" smtClean="0"/>
              <a:t>3/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70AFF-06FA-4B29-8ED9-C4D672D5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53883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8FBC-9304-449D-ACA2-13D6F5143335}" type="datetimeFigureOut">
              <a:rPr lang="en-US" smtClean="0"/>
              <a:t>3/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70AFF-06FA-4B29-8ED9-C4D672D5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67513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8FBC-9304-449D-ACA2-13D6F5143335}" type="datetimeFigureOut">
              <a:rPr lang="en-US" smtClean="0"/>
              <a:t>3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70AFF-06FA-4B29-8ED9-C4D672D5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41414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8FBC-9304-449D-ACA2-13D6F5143335}" type="datetimeFigureOut">
              <a:rPr lang="en-US" smtClean="0"/>
              <a:t>3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70AFF-06FA-4B29-8ED9-C4D672D5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38256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8FBC-9304-449D-ACA2-13D6F5143335}" type="datetimeFigureOut">
              <a:rPr lang="en-US" smtClean="0"/>
              <a:t>3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70AFF-06FA-4B29-8ED9-C4D672D5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7434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8FBC-9304-449D-ACA2-13D6F5143335}" type="datetimeFigureOut">
              <a:rPr lang="en-US" smtClean="0"/>
              <a:t>3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70AFF-06FA-4B29-8ED9-C4D672D5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169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8FBC-9304-449D-ACA2-13D6F5143335}" type="datetimeFigureOut">
              <a:rPr lang="en-US" smtClean="0"/>
              <a:t>3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70AFF-06FA-4B29-8ED9-C4D672D5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357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six conten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2"/>
          <p:cNvSpPr>
            <a:spLocks noGrp="1"/>
          </p:cNvSpPr>
          <p:nvPr>
            <p:ph idx="10"/>
          </p:nvPr>
        </p:nvSpPr>
        <p:spPr>
          <a:xfrm>
            <a:off x="471488" y="471220"/>
            <a:ext cx="5916892" cy="5978347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24" name="Content Placeholder 2"/>
          <p:cNvSpPr>
            <a:spLocks noGrp="1"/>
          </p:cNvSpPr>
          <p:nvPr>
            <p:ph idx="12"/>
          </p:nvPr>
        </p:nvSpPr>
        <p:spPr>
          <a:xfrm>
            <a:off x="471488" y="6616693"/>
            <a:ext cx="2880000" cy="2880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25" name="Content Placeholder 2"/>
          <p:cNvSpPr>
            <a:spLocks noGrp="1"/>
          </p:cNvSpPr>
          <p:nvPr>
            <p:ph idx="13"/>
          </p:nvPr>
        </p:nvSpPr>
        <p:spPr>
          <a:xfrm>
            <a:off x="3508380" y="6614311"/>
            <a:ext cx="2880000" cy="2880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059059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x conten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2"/>
          <p:cNvSpPr>
            <a:spLocks noGrp="1"/>
          </p:cNvSpPr>
          <p:nvPr>
            <p:ph idx="10"/>
          </p:nvPr>
        </p:nvSpPr>
        <p:spPr>
          <a:xfrm>
            <a:off x="471488" y="471221"/>
            <a:ext cx="2880000" cy="2880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6" name="Content Placeholder 2"/>
          <p:cNvSpPr>
            <a:spLocks noGrp="1"/>
          </p:cNvSpPr>
          <p:nvPr>
            <p:ph idx="11"/>
          </p:nvPr>
        </p:nvSpPr>
        <p:spPr>
          <a:xfrm>
            <a:off x="3508380" y="471221"/>
            <a:ext cx="2880000" cy="2880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24" name="Content Placeholder 2"/>
          <p:cNvSpPr>
            <a:spLocks noGrp="1"/>
          </p:cNvSpPr>
          <p:nvPr>
            <p:ph idx="12"/>
          </p:nvPr>
        </p:nvSpPr>
        <p:spPr>
          <a:xfrm>
            <a:off x="471488" y="6327638"/>
            <a:ext cx="2880000" cy="2880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25" name="Content Placeholder 2"/>
          <p:cNvSpPr>
            <a:spLocks noGrp="1"/>
          </p:cNvSpPr>
          <p:nvPr>
            <p:ph idx="13"/>
          </p:nvPr>
        </p:nvSpPr>
        <p:spPr>
          <a:xfrm>
            <a:off x="3508380" y="6327638"/>
            <a:ext cx="2880000" cy="2880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30" name="Content Placeholder 2"/>
          <p:cNvSpPr>
            <a:spLocks noGrp="1"/>
          </p:cNvSpPr>
          <p:nvPr>
            <p:ph idx="14"/>
          </p:nvPr>
        </p:nvSpPr>
        <p:spPr>
          <a:xfrm>
            <a:off x="471488" y="3399429"/>
            <a:ext cx="2880000" cy="2880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31" name="Content Placeholder 2"/>
          <p:cNvSpPr>
            <a:spLocks noGrp="1"/>
          </p:cNvSpPr>
          <p:nvPr>
            <p:ph idx="15"/>
          </p:nvPr>
        </p:nvSpPr>
        <p:spPr>
          <a:xfrm>
            <a:off x="3508380" y="3399429"/>
            <a:ext cx="2880000" cy="2880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525618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2 conten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2"/>
          <p:cNvSpPr>
            <a:spLocks noGrp="1"/>
          </p:cNvSpPr>
          <p:nvPr>
            <p:ph idx="10"/>
          </p:nvPr>
        </p:nvSpPr>
        <p:spPr>
          <a:xfrm>
            <a:off x="252032" y="471221"/>
            <a:ext cx="2088000" cy="2088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2"/>
          <p:cNvSpPr>
            <a:spLocks noGrp="1"/>
          </p:cNvSpPr>
          <p:nvPr>
            <p:ph idx="11"/>
          </p:nvPr>
        </p:nvSpPr>
        <p:spPr>
          <a:xfrm>
            <a:off x="2380414" y="471221"/>
            <a:ext cx="2088000" cy="2088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0" name="Content Placeholder 2"/>
          <p:cNvSpPr>
            <a:spLocks noGrp="1"/>
          </p:cNvSpPr>
          <p:nvPr>
            <p:ph idx="14"/>
          </p:nvPr>
        </p:nvSpPr>
        <p:spPr>
          <a:xfrm>
            <a:off x="252032" y="5048203"/>
            <a:ext cx="2088000" cy="2088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31" name="Content Placeholder 2"/>
          <p:cNvSpPr>
            <a:spLocks noGrp="1"/>
          </p:cNvSpPr>
          <p:nvPr>
            <p:ph idx="15"/>
          </p:nvPr>
        </p:nvSpPr>
        <p:spPr>
          <a:xfrm>
            <a:off x="2380414" y="5048203"/>
            <a:ext cx="2088000" cy="2088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8" name="Content Placeholder 2"/>
          <p:cNvSpPr>
            <a:spLocks noGrp="1"/>
          </p:cNvSpPr>
          <p:nvPr>
            <p:ph idx="16"/>
          </p:nvPr>
        </p:nvSpPr>
        <p:spPr>
          <a:xfrm>
            <a:off x="252032" y="2759712"/>
            <a:ext cx="2088000" cy="2088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9" name="Content Placeholder 2"/>
          <p:cNvSpPr>
            <a:spLocks noGrp="1"/>
          </p:cNvSpPr>
          <p:nvPr>
            <p:ph idx="17"/>
          </p:nvPr>
        </p:nvSpPr>
        <p:spPr>
          <a:xfrm>
            <a:off x="2380414" y="2759712"/>
            <a:ext cx="2088000" cy="2088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0" name="Content Placeholder 2"/>
          <p:cNvSpPr>
            <a:spLocks noGrp="1"/>
          </p:cNvSpPr>
          <p:nvPr>
            <p:ph idx="18"/>
          </p:nvPr>
        </p:nvSpPr>
        <p:spPr>
          <a:xfrm>
            <a:off x="4508796" y="471221"/>
            <a:ext cx="2088000" cy="2088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2" name="Content Placeholder 2"/>
          <p:cNvSpPr>
            <a:spLocks noGrp="1"/>
          </p:cNvSpPr>
          <p:nvPr>
            <p:ph idx="20"/>
          </p:nvPr>
        </p:nvSpPr>
        <p:spPr>
          <a:xfrm>
            <a:off x="4508796" y="5048203"/>
            <a:ext cx="2088000" cy="2088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3" name="Content Placeholder 2"/>
          <p:cNvSpPr>
            <a:spLocks noGrp="1"/>
          </p:cNvSpPr>
          <p:nvPr>
            <p:ph idx="21"/>
          </p:nvPr>
        </p:nvSpPr>
        <p:spPr>
          <a:xfrm>
            <a:off x="4508796" y="2759712"/>
            <a:ext cx="2088000" cy="2088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75363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lide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2"/>
          <p:cNvSpPr>
            <a:spLocks noGrp="1"/>
          </p:cNvSpPr>
          <p:nvPr>
            <p:ph idx="10"/>
          </p:nvPr>
        </p:nvSpPr>
        <p:spPr>
          <a:xfrm>
            <a:off x="471488" y="471221"/>
            <a:ext cx="2880000" cy="2880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6" name="Content Placeholder 2"/>
          <p:cNvSpPr>
            <a:spLocks noGrp="1"/>
          </p:cNvSpPr>
          <p:nvPr>
            <p:ph idx="11"/>
          </p:nvPr>
        </p:nvSpPr>
        <p:spPr>
          <a:xfrm>
            <a:off x="3508380" y="471221"/>
            <a:ext cx="2880000" cy="2880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1" name="Content Placeholder 2"/>
          <p:cNvSpPr>
            <a:spLocks noGrp="1"/>
          </p:cNvSpPr>
          <p:nvPr>
            <p:ph idx="18"/>
          </p:nvPr>
        </p:nvSpPr>
        <p:spPr>
          <a:xfrm>
            <a:off x="471488" y="5042213"/>
            <a:ext cx="1440000" cy="1440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20" name="Content Placeholder 2"/>
          <p:cNvSpPr>
            <a:spLocks noGrp="1"/>
          </p:cNvSpPr>
          <p:nvPr>
            <p:ph idx="21"/>
          </p:nvPr>
        </p:nvSpPr>
        <p:spPr>
          <a:xfrm>
            <a:off x="471488" y="6540469"/>
            <a:ext cx="1440000" cy="1440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22" name="Content Placeholder 2"/>
          <p:cNvSpPr>
            <a:spLocks noGrp="1"/>
          </p:cNvSpPr>
          <p:nvPr>
            <p:ph idx="23"/>
          </p:nvPr>
        </p:nvSpPr>
        <p:spPr>
          <a:xfrm>
            <a:off x="471488" y="8038725"/>
            <a:ext cx="1440000" cy="1440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12" name="Content Placeholder 2"/>
          <p:cNvSpPr>
            <a:spLocks noGrp="1"/>
          </p:cNvSpPr>
          <p:nvPr>
            <p:ph idx="25"/>
          </p:nvPr>
        </p:nvSpPr>
        <p:spPr>
          <a:xfrm>
            <a:off x="1963785" y="5042213"/>
            <a:ext cx="1440000" cy="1440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14" name="Content Placeholder 2"/>
          <p:cNvSpPr>
            <a:spLocks noGrp="1"/>
          </p:cNvSpPr>
          <p:nvPr>
            <p:ph idx="26"/>
          </p:nvPr>
        </p:nvSpPr>
        <p:spPr>
          <a:xfrm>
            <a:off x="1963785" y="6540469"/>
            <a:ext cx="1440000" cy="1440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15" name="Content Placeholder 2"/>
          <p:cNvSpPr>
            <a:spLocks noGrp="1"/>
          </p:cNvSpPr>
          <p:nvPr>
            <p:ph idx="27"/>
          </p:nvPr>
        </p:nvSpPr>
        <p:spPr>
          <a:xfrm>
            <a:off x="1963785" y="8038725"/>
            <a:ext cx="1440000" cy="1440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idx="28"/>
          </p:nvPr>
        </p:nvSpPr>
        <p:spPr>
          <a:xfrm>
            <a:off x="3456082" y="5042213"/>
            <a:ext cx="1440000" cy="1440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18" name="Content Placeholder 2"/>
          <p:cNvSpPr>
            <a:spLocks noGrp="1"/>
          </p:cNvSpPr>
          <p:nvPr>
            <p:ph idx="29"/>
          </p:nvPr>
        </p:nvSpPr>
        <p:spPr>
          <a:xfrm>
            <a:off x="3456082" y="6540469"/>
            <a:ext cx="1440000" cy="1440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24" name="Content Placeholder 2"/>
          <p:cNvSpPr>
            <a:spLocks noGrp="1"/>
          </p:cNvSpPr>
          <p:nvPr>
            <p:ph idx="31"/>
          </p:nvPr>
        </p:nvSpPr>
        <p:spPr>
          <a:xfrm>
            <a:off x="4948380" y="5042213"/>
            <a:ext cx="1440000" cy="1440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25" name="Content Placeholder 2"/>
          <p:cNvSpPr>
            <a:spLocks noGrp="1"/>
          </p:cNvSpPr>
          <p:nvPr>
            <p:ph idx="32"/>
          </p:nvPr>
        </p:nvSpPr>
        <p:spPr>
          <a:xfrm>
            <a:off x="4948380" y="6540469"/>
            <a:ext cx="1440000" cy="1440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27" name="Content Placeholder 2"/>
          <p:cNvSpPr>
            <a:spLocks noGrp="1"/>
          </p:cNvSpPr>
          <p:nvPr>
            <p:ph idx="33"/>
          </p:nvPr>
        </p:nvSpPr>
        <p:spPr>
          <a:xfrm>
            <a:off x="3456082" y="8038725"/>
            <a:ext cx="1440000" cy="1440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28" name="Content Placeholder 2"/>
          <p:cNvSpPr>
            <a:spLocks noGrp="1"/>
          </p:cNvSpPr>
          <p:nvPr>
            <p:ph idx="34"/>
          </p:nvPr>
        </p:nvSpPr>
        <p:spPr>
          <a:xfrm>
            <a:off x="4948380" y="8038725"/>
            <a:ext cx="1440000" cy="1440000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956713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8FBC-9304-449D-ACA2-13D6F5143335}" type="datetimeFigureOut">
              <a:rPr lang="en-US" smtClean="0"/>
              <a:t>3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70AFF-06FA-4B29-8ED9-C4D672D5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6378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8FBC-9304-449D-ACA2-13D6F5143335}" type="datetimeFigureOut">
              <a:rPr lang="en-US" smtClean="0"/>
              <a:t>3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70AFF-06FA-4B29-8ED9-C4D672D5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0480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8FBC-9304-449D-ACA2-13D6F5143335}" type="datetimeFigureOut">
              <a:rPr lang="en-US" smtClean="0"/>
              <a:t>3/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70AFF-06FA-4B29-8ED9-C4D672D5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2598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F98FBC-9304-449D-ACA2-13D6F5143335}" type="datetimeFigureOut">
              <a:rPr lang="en-US" smtClean="0"/>
              <a:t>3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F70AFF-06FA-4B29-8ED9-C4D672D5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292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73" r:id="rId3"/>
    <p:sldLayoutId id="2147483672" r:id="rId4"/>
    <p:sldLayoutId id="2147483675" r:id="rId5"/>
    <p:sldLayoutId id="2147483674" r:id="rId6"/>
    <p:sldLayoutId id="2147483663" r:id="rId7"/>
    <p:sldLayoutId id="2147483664" r:id="rId8"/>
    <p:sldLayoutId id="2147483665" r:id="rId9"/>
    <p:sldLayoutId id="2147483666" r:id="rId10"/>
    <p:sldLayoutId id="2147483667" r:id="rId11"/>
    <p:sldLayoutId id="2147483668" r:id="rId12"/>
    <p:sldLayoutId id="2147483669" r:id="rId13"/>
    <p:sldLayoutId id="2147483670" r:id="rId14"/>
    <p:sldLayoutId id="2147483671" r:id="rId15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Diagramm 11"/>
          <p:cNvGraphicFramePr>
            <a:graphicFrameLocks noGrp="1"/>
          </p:cNvGraphicFramePr>
          <p:nvPr>
            <p:ph idx="10"/>
            <p:extLst>
              <p:ext uri="{D42A27DB-BD31-4B8C-83A1-F6EECF244321}">
                <p14:modId xmlns:p14="http://schemas.microsoft.com/office/powerpoint/2010/main" val="1698250768"/>
              </p:ext>
            </p:extLst>
          </p:nvPr>
        </p:nvGraphicFramePr>
        <p:xfrm>
          <a:off x="471488" y="840553"/>
          <a:ext cx="5916892" cy="28797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Rectangle 3"/>
          <p:cNvSpPr/>
          <p:nvPr/>
        </p:nvSpPr>
        <p:spPr>
          <a:xfrm>
            <a:off x="139320" y="70100"/>
            <a:ext cx="10887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87034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0" name="Rectangle 1089"/>
          <p:cNvSpPr/>
          <p:nvPr/>
        </p:nvSpPr>
        <p:spPr>
          <a:xfrm>
            <a:off x="139320" y="70100"/>
            <a:ext cx="1088760" cy="369332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202" name="Gruppieren 5201">
            <a:extLst>
              <a:ext uri="{FF2B5EF4-FFF2-40B4-BE49-F238E27FC236}">
                <a16:creationId xmlns:a16="http://schemas.microsoft.com/office/drawing/2014/main" id="{31471EF2-4ACA-4E85-B459-1FC80049CEFA}"/>
              </a:ext>
            </a:extLst>
          </p:cNvPr>
          <p:cNvGrpSpPr/>
          <p:nvPr/>
        </p:nvGrpSpPr>
        <p:grpSpPr>
          <a:xfrm>
            <a:off x="630032" y="840553"/>
            <a:ext cx="5516061" cy="3092356"/>
            <a:chOff x="630032" y="4041420"/>
            <a:chExt cx="5516061" cy="3092356"/>
          </a:xfrm>
        </p:grpSpPr>
        <p:sp>
          <p:nvSpPr>
            <p:cNvPr id="5137" name="Line 124">
              <a:extLst>
                <a:ext uri="{FF2B5EF4-FFF2-40B4-BE49-F238E27FC236}">
                  <a16:creationId xmlns:a16="http://schemas.microsoft.com/office/drawing/2014/main" id="{E315C7FD-574C-455C-AC9D-E5BEF137E2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06093" y="4115622"/>
              <a:ext cx="0" cy="2590800"/>
            </a:xfrm>
            <a:prstGeom prst="line">
              <a:avLst/>
            </a:prstGeom>
            <a:noFill/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38" name="Rectangle 125">
              <a:extLst>
                <a:ext uri="{FF2B5EF4-FFF2-40B4-BE49-F238E27FC236}">
                  <a16:creationId xmlns:a16="http://schemas.microsoft.com/office/drawing/2014/main" id="{E943CD59-1CED-4BEE-BBB7-CCAA582B2D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0761" y="6210371"/>
              <a:ext cx="22442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5</a:t>
              </a:r>
            </a:p>
          </p:txBody>
        </p:sp>
        <p:sp>
          <p:nvSpPr>
            <p:cNvPr id="5139" name="Rectangle 126">
              <a:extLst>
                <a:ext uri="{FF2B5EF4-FFF2-40B4-BE49-F238E27FC236}">
                  <a16:creationId xmlns:a16="http://schemas.microsoft.com/office/drawing/2014/main" id="{36FCC760-AF22-45FD-B52B-9A4BABADE7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0761" y="5465834"/>
              <a:ext cx="22442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0</a:t>
              </a:r>
            </a:p>
          </p:txBody>
        </p:sp>
        <p:sp>
          <p:nvSpPr>
            <p:cNvPr id="5140" name="Rectangle 127">
              <a:extLst>
                <a:ext uri="{FF2B5EF4-FFF2-40B4-BE49-F238E27FC236}">
                  <a16:creationId xmlns:a16="http://schemas.microsoft.com/office/drawing/2014/main" id="{B80B9361-3972-4F2A-BDE3-D139FEF739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0761" y="4718423"/>
              <a:ext cx="22442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5</a:t>
              </a:r>
            </a:p>
          </p:txBody>
        </p:sp>
        <p:sp>
          <p:nvSpPr>
            <p:cNvPr id="5141" name="Line 128">
              <a:extLst>
                <a:ext uri="{FF2B5EF4-FFF2-40B4-BE49-F238E27FC236}">
                  <a16:creationId xmlns:a16="http://schemas.microsoft.com/office/drawing/2014/main" id="{A504EF6D-29D5-47CB-80E7-4D6B9E3382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66493" y="6285735"/>
              <a:ext cx="39600" cy="0"/>
            </a:xfrm>
            <a:prstGeom prst="line">
              <a:avLst/>
            </a:prstGeom>
            <a:noFill/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42" name="Line 129">
              <a:extLst>
                <a:ext uri="{FF2B5EF4-FFF2-40B4-BE49-F238E27FC236}">
                  <a16:creationId xmlns:a16="http://schemas.microsoft.com/office/drawing/2014/main" id="{B060F0FC-358F-405F-9794-4AA52BB50E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66493" y="5541197"/>
              <a:ext cx="39600" cy="0"/>
            </a:xfrm>
            <a:prstGeom prst="line">
              <a:avLst/>
            </a:prstGeom>
            <a:noFill/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43" name="Line 130">
              <a:extLst>
                <a:ext uri="{FF2B5EF4-FFF2-40B4-BE49-F238E27FC236}">
                  <a16:creationId xmlns:a16="http://schemas.microsoft.com/office/drawing/2014/main" id="{DBD632D9-6500-47D2-98D5-869170E7035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66493" y="4790310"/>
              <a:ext cx="39600" cy="0"/>
            </a:xfrm>
            <a:prstGeom prst="line">
              <a:avLst/>
            </a:prstGeom>
            <a:noFill/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44" name="Line 131">
              <a:extLst>
                <a:ext uri="{FF2B5EF4-FFF2-40B4-BE49-F238E27FC236}">
                  <a16:creationId xmlns:a16="http://schemas.microsoft.com/office/drawing/2014/main" id="{B68CFF33-DB8F-4E2E-8560-2214511220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06093" y="6706422"/>
              <a:ext cx="5040000" cy="0"/>
            </a:xfrm>
            <a:prstGeom prst="line">
              <a:avLst/>
            </a:prstGeom>
            <a:noFill/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199" name="Gruppieren 5198">
              <a:extLst>
                <a:ext uri="{FF2B5EF4-FFF2-40B4-BE49-F238E27FC236}">
                  <a16:creationId xmlns:a16="http://schemas.microsoft.com/office/drawing/2014/main" id="{6B63AA60-A97D-4160-8CD6-77B5B9D1307C}"/>
                </a:ext>
              </a:extLst>
            </p:cNvPr>
            <p:cNvGrpSpPr/>
            <p:nvPr/>
          </p:nvGrpSpPr>
          <p:grpSpPr>
            <a:xfrm>
              <a:off x="1627357" y="4210872"/>
              <a:ext cx="391133" cy="2729429"/>
              <a:chOff x="1627357" y="4210872"/>
              <a:chExt cx="391133" cy="2729429"/>
            </a:xfrm>
          </p:grpSpPr>
          <p:sp>
            <p:nvSpPr>
              <p:cNvPr id="5032" name="Oval 19">
                <a:extLst>
                  <a:ext uri="{FF2B5EF4-FFF2-40B4-BE49-F238E27FC236}">
                    <a16:creationId xmlns:a16="http://schemas.microsoft.com/office/drawing/2014/main" id="{2EED546B-20AF-4649-B849-23FA7C2BDF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4210872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34" name="Oval 21">
                <a:extLst>
                  <a:ext uri="{FF2B5EF4-FFF2-40B4-BE49-F238E27FC236}">
                    <a16:creationId xmlns:a16="http://schemas.microsoft.com/office/drawing/2014/main" id="{1568DA33-5FF4-4437-8FC8-F339EA4EBE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42848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35" name="Oval 22">
                <a:extLst>
                  <a:ext uri="{FF2B5EF4-FFF2-40B4-BE49-F238E27FC236}">
                    <a16:creationId xmlns:a16="http://schemas.microsoft.com/office/drawing/2014/main" id="{28A70D87-CE06-490A-A115-627910D8BB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19194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39" name="Oval 26">
                <a:extLst>
                  <a:ext uri="{FF2B5EF4-FFF2-40B4-BE49-F238E27FC236}">
                    <a16:creationId xmlns:a16="http://schemas.microsoft.com/office/drawing/2014/main" id="{92E8332C-BAC9-4B52-B767-22C5856755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59993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40" name="Oval 27">
                <a:extLst>
                  <a:ext uri="{FF2B5EF4-FFF2-40B4-BE49-F238E27FC236}">
                    <a16:creationId xmlns:a16="http://schemas.microsoft.com/office/drawing/2014/main" id="{A17513AF-8CD5-4695-AA75-D27A3259CF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14432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41" name="Oval 28">
                <a:extLst>
                  <a:ext uri="{FF2B5EF4-FFF2-40B4-BE49-F238E27FC236}">
                    <a16:creationId xmlns:a16="http://schemas.microsoft.com/office/drawing/2014/main" id="{936065CA-A57D-4D11-BBF7-EBCE4A458A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484269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57" name="Oval 44">
                <a:extLst>
                  <a:ext uri="{FF2B5EF4-FFF2-40B4-BE49-F238E27FC236}">
                    <a16:creationId xmlns:a16="http://schemas.microsoft.com/office/drawing/2014/main" id="{4A46343A-EE83-448F-8E28-85153FEF3F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42848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59" name="Oval 46">
                <a:extLst>
                  <a:ext uri="{FF2B5EF4-FFF2-40B4-BE49-F238E27FC236}">
                    <a16:creationId xmlns:a16="http://schemas.microsoft.com/office/drawing/2014/main" id="{77BF7731-0788-48D0-90FE-88457FD745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13797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60" name="Oval 47">
                <a:extLst>
                  <a:ext uri="{FF2B5EF4-FFF2-40B4-BE49-F238E27FC236}">
                    <a16:creationId xmlns:a16="http://schemas.microsoft.com/office/drawing/2014/main" id="{6D286371-056D-40C4-AC76-26A7BBC06F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36339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61" name="Oval 48">
                <a:extLst>
                  <a:ext uri="{FF2B5EF4-FFF2-40B4-BE49-F238E27FC236}">
                    <a16:creationId xmlns:a16="http://schemas.microsoft.com/office/drawing/2014/main" id="{51B96EDC-A97E-4021-BD91-F54EE88EF3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10304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62" name="Oval 49">
                <a:extLst>
                  <a:ext uri="{FF2B5EF4-FFF2-40B4-BE49-F238E27FC236}">
                    <a16:creationId xmlns:a16="http://schemas.microsoft.com/office/drawing/2014/main" id="{05666365-80E9-4B87-8458-768B068C77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458647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78" name="Oval 65">
                <a:extLst>
                  <a:ext uri="{FF2B5EF4-FFF2-40B4-BE49-F238E27FC236}">
                    <a16:creationId xmlns:a16="http://schemas.microsoft.com/office/drawing/2014/main" id="{C976F9EE-C913-45D0-85FA-6D1FD5AAE4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287197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79" name="Oval 66">
                <a:extLst>
                  <a:ext uri="{FF2B5EF4-FFF2-40B4-BE49-F238E27FC236}">
                    <a16:creationId xmlns:a16="http://schemas.microsoft.com/office/drawing/2014/main" id="{070D103C-24B2-4EE4-A685-1A2FF1A640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38086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81" name="Oval 68">
                <a:extLst>
                  <a:ext uri="{FF2B5EF4-FFF2-40B4-BE49-F238E27FC236}">
                    <a16:creationId xmlns:a16="http://schemas.microsoft.com/office/drawing/2014/main" id="{2BA874FA-470D-4BE8-9976-89C2262557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32212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82" name="Oval 69">
                <a:extLst>
                  <a:ext uri="{FF2B5EF4-FFF2-40B4-BE49-F238E27FC236}">
                    <a16:creationId xmlns:a16="http://schemas.microsoft.com/office/drawing/2014/main" id="{A11873BC-FB93-4E2C-AA44-1FF66F9EC5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57612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83" name="Oval 70">
                <a:extLst>
                  <a:ext uri="{FF2B5EF4-FFF2-40B4-BE49-F238E27FC236}">
                    <a16:creationId xmlns:a16="http://schemas.microsoft.com/office/drawing/2014/main" id="{0341F1DC-B7DF-4EC0-BD45-FD55796DAE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31577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84" name="Oval 71">
                <a:extLst>
                  <a:ext uri="{FF2B5EF4-FFF2-40B4-BE49-F238E27FC236}">
                    <a16:creationId xmlns:a16="http://schemas.microsoft.com/office/drawing/2014/main" id="{7D4ADB92-ED71-4282-934B-1D3A746F91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4985572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85" name="Oval 72">
                <a:extLst>
                  <a:ext uri="{FF2B5EF4-FFF2-40B4-BE49-F238E27FC236}">
                    <a16:creationId xmlns:a16="http://schemas.microsoft.com/office/drawing/2014/main" id="{DAF8E1C3-E5D6-475F-9EFD-35CFC4833A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55231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87" name="Oval 74">
                <a:extLst>
                  <a:ext uri="{FF2B5EF4-FFF2-40B4-BE49-F238E27FC236}">
                    <a16:creationId xmlns:a16="http://schemas.microsoft.com/office/drawing/2014/main" id="{D5061496-1394-470B-A58C-867695C768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70629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88" name="Oval 75">
                <a:extLst>
                  <a:ext uri="{FF2B5EF4-FFF2-40B4-BE49-F238E27FC236}">
                    <a16:creationId xmlns:a16="http://schemas.microsoft.com/office/drawing/2014/main" id="{7D7D7BAE-F433-43F5-84DF-676BDDCE72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42213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02" name="Oval 89">
                <a:extLst>
                  <a:ext uri="{FF2B5EF4-FFF2-40B4-BE49-F238E27FC236}">
                    <a16:creationId xmlns:a16="http://schemas.microsoft.com/office/drawing/2014/main" id="{AE50C98C-A99C-4013-B59A-4B5FD27A05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38721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04" name="Oval 91">
                <a:extLst>
                  <a:ext uri="{FF2B5EF4-FFF2-40B4-BE49-F238E27FC236}">
                    <a16:creationId xmlns:a16="http://schemas.microsoft.com/office/drawing/2014/main" id="{4B25012E-DD6E-4143-BD57-FDE9CB250F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57612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05" name="Oval 92">
                <a:extLst>
                  <a:ext uri="{FF2B5EF4-FFF2-40B4-BE49-F238E27FC236}">
                    <a16:creationId xmlns:a16="http://schemas.microsoft.com/office/drawing/2014/main" id="{8963DF95-BBD7-4173-BAE9-4C54B886D5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6274622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08" name="Oval 95">
                <a:extLst>
                  <a:ext uri="{FF2B5EF4-FFF2-40B4-BE49-F238E27FC236}">
                    <a16:creationId xmlns:a16="http://schemas.microsoft.com/office/drawing/2014/main" id="{C90362E6-0E15-4973-8EA9-4B83506F1F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695185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11" name="Oval 98">
                <a:extLst>
                  <a:ext uri="{FF2B5EF4-FFF2-40B4-BE49-F238E27FC236}">
                    <a16:creationId xmlns:a16="http://schemas.microsoft.com/office/drawing/2014/main" id="{87AAA715-8AA7-4107-B66A-6266AECDFE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67137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12" name="Oval 99">
                <a:extLst>
                  <a:ext uri="{FF2B5EF4-FFF2-40B4-BE49-F238E27FC236}">
                    <a16:creationId xmlns:a16="http://schemas.microsoft.com/office/drawing/2014/main" id="{CB313BA0-CE79-4970-8C52-312856846B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83012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25" name="Oval 112">
                <a:extLst>
                  <a:ext uri="{FF2B5EF4-FFF2-40B4-BE49-F238E27FC236}">
                    <a16:creationId xmlns:a16="http://schemas.microsoft.com/office/drawing/2014/main" id="{6642EECE-79FE-472A-B410-D7B267A23E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86028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26" name="Oval 113">
                <a:extLst>
                  <a:ext uri="{FF2B5EF4-FFF2-40B4-BE49-F238E27FC236}">
                    <a16:creationId xmlns:a16="http://schemas.microsoft.com/office/drawing/2014/main" id="{96D25F4F-9EEE-426D-889B-8B53EE8FF5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890447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27" name="Oval 114">
                <a:extLst>
                  <a:ext uri="{FF2B5EF4-FFF2-40B4-BE49-F238E27FC236}">
                    <a16:creationId xmlns:a16="http://schemas.microsoft.com/office/drawing/2014/main" id="{B763752D-742A-418A-B348-4DA21FA444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955535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30" name="Oval 117">
                <a:extLst>
                  <a:ext uri="{FF2B5EF4-FFF2-40B4-BE49-F238E27FC236}">
                    <a16:creationId xmlns:a16="http://schemas.microsoft.com/office/drawing/2014/main" id="{516D4E5A-018D-49D4-BD91-B32ACF27AE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61739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31" name="Oval 118">
                <a:extLst>
                  <a:ext uri="{FF2B5EF4-FFF2-40B4-BE49-F238E27FC236}">
                    <a16:creationId xmlns:a16="http://schemas.microsoft.com/office/drawing/2014/main" id="{EFE25FAB-C543-48B8-8010-6ECF4F3155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784085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32" name="Oval 119">
                <a:extLst>
                  <a:ext uri="{FF2B5EF4-FFF2-40B4-BE49-F238E27FC236}">
                    <a16:creationId xmlns:a16="http://schemas.microsoft.com/office/drawing/2014/main" id="{AC1C039C-C156-48D7-9C57-5391ED0223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75392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34" name="Oval 121">
                <a:extLst>
                  <a:ext uri="{FF2B5EF4-FFF2-40B4-BE49-F238E27FC236}">
                    <a16:creationId xmlns:a16="http://schemas.microsoft.com/office/drawing/2014/main" id="{95FFF7D1-A77B-48B1-A6E3-7FF0A0EC1D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79519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35" name="Oval 122">
                <a:extLst>
                  <a:ext uri="{FF2B5EF4-FFF2-40B4-BE49-F238E27FC236}">
                    <a16:creationId xmlns:a16="http://schemas.microsoft.com/office/drawing/2014/main" id="{FD000C52-995A-4394-B2BC-5EB9AE633E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87774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36" name="Oval 123">
                <a:extLst>
                  <a:ext uri="{FF2B5EF4-FFF2-40B4-BE49-F238E27FC236}">
                    <a16:creationId xmlns:a16="http://schemas.microsoft.com/office/drawing/2014/main" id="{9E574B3A-4662-4A68-BF91-7ED75B1A73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9111" y="520306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45" name="Line 132">
                <a:extLst>
                  <a:ext uri="{FF2B5EF4-FFF2-40B4-BE49-F238E27FC236}">
                    <a16:creationId xmlns:a16="http://schemas.microsoft.com/office/drawing/2014/main" id="{2128F285-955C-420E-A270-26E60EF2B0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822923" y="6706421"/>
                <a:ext cx="0" cy="3960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49" name="Rectangle 136">
                <a:extLst>
                  <a:ext uri="{FF2B5EF4-FFF2-40B4-BE49-F238E27FC236}">
                    <a16:creationId xmlns:a16="http://schemas.microsoft.com/office/drawing/2014/main" id="{B20E7350-C50E-4AB2-9CE2-93B17ECF4B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27357" y="6786413"/>
                <a:ext cx="391133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000" b="0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</a:p>
            </p:txBody>
          </p:sp>
        </p:grpSp>
        <p:grpSp>
          <p:nvGrpSpPr>
            <p:cNvPr id="5198" name="Gruppieren 5197">
              <a:extLst>
                <a:ext uri="{FF2B5EF4-FFF2-40B4-BE49-F238E27FC236}">
                  <a16:creationId xmlns:a16="http://schemas.microsoft.com/office/drawing/2014/main" id="{6BD9376A-7FD2-4047-AB98-0DED8349861D}"/>
                </a:ext>
              </a:extLst>
            </p:cNvPr>
            <p:cNvGrpSpPr/>
            <p:nvPr/>
          </p:nvGrpSpPr>
          <p:grpSpPr>
            <a:xfrm>
              <a:off x="2846035" y="4423597"/>
              <a:ext cx="291747" cy="2516704"/>
              <a:chOff x="2747334" y="4423597"/>
              <a:chExt cx="291747" cy="2516704"/>
            </a:xfrm>
          </p:grpSpPr>
          <p:sp>
            <p:nvSpPr>
              <p:cNvPr id="5023" name="Oval 10">
                <a:extLst>
                  <a:ext uri="{FF2B5EF4-FFF2-40B4-BE49-F238E27FC236}">
                    <a16:creationId xmlns:a16="http://schemas.microsoft.com/office/drawing/2014/main" id="{13A91BD3-B78E-4F7B-BDE9-902C86DC3F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599046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27" name="Oval 14">
                <a:extLst>
                  <a:ext uri="{FF2B5EF4-FFF2-40B4-BE49-F238E27FC236}">
                    <a16:creationId xmlns:a16="http://schemas.microsoft.com/office/drawing/2014/main" id="{8CAEBC90-0D9B-43A3-8915-63C8B90B2C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442359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29" name="Oval 16">
                <a:extLst>
                  <a:ext uri="{FF2B5EF4-FFF2-40B4-BE49-F238E27FC236}">
                    <a16:creationId xmlns:a16="http://schemas.microsoft.com/office/drawing/2014/main" id="{D535C964-1C2B-44D3-89D0-E4FBC369DB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462997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30" name="Oval 17">
                <a:extLst>
                  <a:ext uri="{FF2B5EF4-FFF2-40B4-BE49-F238E27FC236}">
                    <a16:creationId xmlns:a16="http://schemas.microsoft.com/office/drawing/2014/main" id="{8A267FFA-E168-4D71-BE29-F23FA23A0D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530466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46" name="Oval 33">
                <a:extLst>
                  <a:ext uri="{FF2B5EF4-FFF2-40B4-BE49-F238E27FC236}">
                    <a16:creationId xmlns:a16="http://schemas.microsoft.com/office/drawing/2014/main" id="{D48272AC-FCAD-4C1E-9DC9-16248AE33C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522687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48" name="Oval 35">
                <a:extLst>
                  <a:ext uri="{FF2B5EF4-FFF2-40B4-BE49-F238E27FC236}">
                    <a16:creationId xmlns:a16="http://schemas.microsoft.com/office/drawing/2014/main" id="{9CF87E96-074B-4C8A-A141-2C8B7BD073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5393560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49" name="Oval 36">
                <a:extLst>
                  <a:ext uri="{FF2B5EF4-FFF2-40B4-BE49-F238E27FC236}">
                    <a16:creationId xmlns:a16="http://schemas.microsoft.com/office/drawing/2014/main" id="{6E57FB29-0E14-4657-8B4C-C708431077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525703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65" name="Oval 52">
                <a:extLst>
                  <a:ext uri="{FF2B5EF4-FFF2-40B4-BE49-F238E27FC236}">
                    <a16:creationId xmlns:a16="http://schemas.microsoft.com/office/drawing/2014/main" id="{F686F139-5B7C-49DC-8931-93BFC62D84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528084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68" name="Oval 55">
                <a:extLst>
                  <a:ext uri="{FF2B5EF4-FFF2-40B4-BE49-F238E27FC236}">
                    <a16:creationId xmlns:a16="http://schemas.microsoft.com/office/drawing/2014/main" id="{50415D9D-F984-4EB9-81CA-9D9BFFF9FC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544594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71" name="Oval 58">
                <a:extLst>
                  <a:ext uri="{FF2B5EF4-FFF2-40B4-BE49-F238E27FC236}">
                    <a16:creationId xmlns:a16="http://schemas.microsoft.com/office/drawing/2014/main" id="{BB22D18B-B33F-48B2-B5D1-3511067F26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5009385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74" name="Oval 61">
                <a:extLst>
                  <a:ext uri="{FF2B5EF4-FFF2-40B4-BE49-F238E27FC236}">
                    <a16:creationId xmlns:a16="http://schemas.microsoft.com/office/drawing/2014/main" id="{AC9AACBF-AF5A-4243-97BC-3423F1FA1F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6469885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75" name="Oval 62">
                <a:extLst>
                  <a:ext uri="{FF2B5EF4-FFF2-40B4-BE49-F238E27FC236}">
                    <a16:creationId xmlns:a16="http://schemas.microsoft.com/office/drawing/2014/main" id="{FC0B6AE2-75E0-47DF-886C-063D5C00CA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561739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89" name="Oval 76">
                <a:extLst>
                  <a:ext uri="{FF2B5EF4-FFF2-40B4-BE49-F238E27FC236}">
                    <a16:creationId xmlns:a16="http://schemas.microsoft.com/office/drawing/2014/main" id="{287FDBE0-A77B-492E-9E08-47DE33CDD8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507923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95" name="Oval 82">
                <a:extLst>
                  <a:ext uri="{FF2B5EF4-FFF2-40B4-BE49-F238E27FC236}">
                    <a16:creationId xmlns:a16="http://schemas.microsoft.com/office/drawing/2014/main" id="{DA65EC2D-2D94-4A92-9A95-29C6678C7F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555866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99" name="Oval 86">
                <a:extLst>
                  <a:ext uri="{FF2B5EF4-FFF2-40B4-BE49-F238E27FC236}">
                    <a16:creationId xmlns:a16="http://schemas.microsoft.com/office/drawing/2014/main" id="{4D87F1B6-CC56-4EFA-B0BB-5BE70CD1FD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573011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14" name="Oval 101">
                <a:extLst>
                  <a:ext uri="{FF2B5EF4-FFF2-40B4-BE49-F238E27FC236}">
                    <a16:creationId xmlns:a16="http://schemas.microsoft.com/office/drawing/2014/main" id="{B3CA53FD-96FE-4D6A-A8F5-5FC130FCB9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575392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15" name="Oval 102">
                <a:extLst>
                  <a:ext uri="{FF2B5EF4-FFF2-40B4-BE49-F238E27FC236}">
                    <a16:creationId xmlns:a16="http://schemas.microsoft.com/office/drawing/2014/main" id="{12543B51-7E16-4923-8EE1-8F4180022D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609047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19" name="Oval 106">
                <a:extLst>
                  <a:ext uri="{FF2B5EF4-FFF2-40B4-BE49-F238E27FC236}">
                    <a16:creationId xmlns:a16="http://schemas.microsoft.com/office/drawing/2014/main" id="{978C7996-247D-4AF9-9EB9-D23FEA84C9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597776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20" name="Oval 107">
                <a:extLst>
                  <a:ext uri="{FF2B5EF4-FFF2-40B4-BE49-F238E27FC236}">
                    <a16:creationId xmlns:a16="http://schemas.microsoft.com/office/drawing/2014/main" id="{68519966-6300-4696-9761-735298EDD7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611428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21" name="Oval 108">
                <a:extLst>
                  <a:ext uri="{FF2B5EF4-FFF2-40B4-BE49-F238E27FC236}">
                    <a16:creationId xmlns:a16="http://schemas.microsoft.com/office/drawing/2014/main" id="{62958427-A892-48EA-94A9-75AEA259A5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564756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23" name="Oval 110">
                <a:extLst>
                  <a:ext uri="{FF2B5EF4-FFF2-40B4-BE49-F238E27FC236}">
                    <a16:creationId xmlns:a16="http://schemas.microsoft.com/office/drawing/2014/main" id="{382BDF34-D0F0-4DE1-AB5B-8236306E30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395" y="579519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47" name="Line 134">
                <a:extLst>
                  <a:ext uri="{FF2B5EF4-FFF2-40B4-BE49-F238E27FC236}">
                    <a16:creationId xmlns:a16="http://schemas.microsoft.com/office/drawing/2014/main" id="{EFC204C2-7AC8-41FC-A204-894EDA86E8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93207" y="6706421"/>
                <a:ext cx="0" cy="3960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51" name="Rectangle 138">
                <a:extLst>
                  <a:ext uri="{FF2B5EF4-FFF2-40B4-BE49-F238E27FC236}">
                    <a16:creationId xmlns:a16="http://schemas.microsoft.com/office/drawing/2014/main" id="{36ADA9F6-A3A8-4490-85F2-CC8F6A48D2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47334" y="6786413"/>
                <a:ext cx="291747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000" b="0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CR</a:t>
                </a:r>
              </a:p>
            </p:txBody>
          </p:sp>
        </p:grpSp>
        <p:grpSp>
          <p:nvGrpSpPr>
            <p:cNvPr id="5196" name="Gruppieren 5195">
              <a:extLst>
                <a:ext uri="{FF2B5EF4-FFF2-40B4-BE49-F238E27FC236}">
                  <a16:creationId xmlns:a16="http://schemas.microsoft.com/office/drawing/2014/main" id="{65CD3F8D-DF03-44A3-B691-1727C075C310}"/>
                </a:ext>
              </a:extLst>
            </p:cNvPr>
            <p:cNvGrpSpPr/>
            <p:nvPr/>
          </p:nvGrpSpPr>
          <p:grpSpPr>
            <a:xfrm>
              <a:off x="4999659" y="4695060"/>
              <a:ext cx="570669" cy="2245241"/>
              <a:chOff x="4999659" y="4695060"/>
              <a:chExt cx="570669" cy="2245241"/>
            </a:xfrm>
          </p:grpSpPr>
          <p:sp>
            <p:nvSpPr>
              <p:cNvPr id="5020" name="Oval 7">
                <a:extLst>
                  <a:ext uri="{FF2B5EF4-FFF2-40B4-BE49-F238E27FC236}">
                    <a16:creationId xmlns:a16="http://schemas.microsoft.com/office/drawing/2014/main" id="{E40B08C0-0058-4198-96C1-C1E3B0409E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494906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21" name="Oval 8">
                <a:extLst>
                  <a:ext uri="{FF2B5EF4-FFF2-40B4-BE49-F238E27FC236}">
                    <a16:creationId xmlns:a16="http://schemas.microsoft.com/office/drawing/2014/main" id="{C6455C8E-FE9B-4796-87DB-C1C9B0C39C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67613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22" name="Oval 9">
                <a:extLst>
                  <a:ext uri="{FF2B5EF4-FFF2-40B4-BE49-F238E27FC236}">
                    <a16:creationId xmlns:a16="http://schemas.microsoft.com/office/drawing/2014/main" id="{23CEBDD5-E73E-4A92-8286-671C55F59A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287197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24" name="Oval 11">
                <a:extLst>
                  <a:ext uri="{FF2B5EF4-FFF2-40B4-BE49-F238E27FC236}">
                    <a16:creationId xmlns:a16="http://schemas.microsoft.com/office/drawing/2014/main" id="{CD880295-61BD-4501-BFCB-B77D04D181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16813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25" name="Oval 12">
                <a:extLst>
                  <a:ext uri="{FF2B5EF4-FFF2-40B4-BE49-F238E27FC236}">
                    <a16:creationId xmlns:a16="http://schemas.microsoft.com/office/drawing/2014/main" id="{33A32C6A-114C-4F65-A2E2-0EC11A9D29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29831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26" name="Oval 13">
                <a:extLst>
                  <a:ext uri="{FF2B5EF4-FFF2-40B4-BE49-F238E27FC236}">
                    <a16:creationId xmlns:a16="http://schemas.microsoft.com/office/drawing/2014/main" id="{5B1CD2C2-BCB9-423C-A21B-C93C07F984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19829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28" name="Oval 15">
                <a:extLst>
                  <a:ext uri="{FF2B5EF4-FFF2-40B4-BE49-F238E27FC236}">
                    <a16:creationId xmlns:a16="http://schemas.microsoft.com/office/drawing/2014/main" id="{4D33BD3A-0753-43BA-AF0B-A025226CB9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115747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42" name="Oval 29">
                <a:extLst>
                  <a:ext uri="{FF2B5EF4-FFF2-40B4-BE49-F238E27FC236}">
                    <a16:creationId xmlns:a16="http://schemas.microsoft.com/office/drawing/2014/main" id="{5BB021C9-D18C-4BE2-ADC9-8FF7ACE728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31577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43" name="Oval 30">
                <a:extLst>
                  <a:ext uri="{FF2B5EF4-FFF2-40B4-BE49-F238E27FC236}">
                    <a16:creationId xmlns:a16="http://schemas.microsoft.com/office/drawing/2014/main" id="{F8959543-04DD-4408-B85C-8C9DBE8766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496652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44" name="Oval 31">
                <a:extLst>
                  <a:ext uri="{FF2B5EF4-FFF2-40B4-BE49-F238E27FC236}">
                    <a16:creationId xmlns:a16="http://schemas.microsoft.com/office/drawing/2014/main" id="{1240351E-8889-46D8-B2BC-0DC78C177F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32212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45" name="Oval 32">
                <a:extLst>
                  <a:ext uri="{FF2B5EF4-FFF2-40B4-BE49-F238E27FC236}">
                    <a16:creationId xmlns:a16="http://schemas.microsoft.com/office/drawing/2014/main" id="{430D61DC-1CEB-4290-9794-A23330763D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622064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47" name="Oval 34">
                <a:extLst>
                  <a:ext uri="{FF2B5EF4-FFF2-40B4-BE49-F238E27FC236}">
                    <a16:creationId xmlns:a16="http://schemas.microsoft.com/office/drawing/2014/main" id="{7B772DCE-FC5B-4D83-9BEA-BD374E8739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469506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50" name="Oval 37">
                <a:extLst>
                  <a:ext uri="{FF2B5EF4-FFF2-40B4-BE49-F238E27FC236}">
                    <a16:creationId xmlns:a16="http://schemas.microsoft.com/office/drawing/2014/main" id="{B74747AE-6A9C-4F80-BD7A-F58C9961FE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48722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51" name="Oval 38">
                <a:extLst>
                  <a:ext uri="{FF2B5EF4-FFF2-40B4-BE49-F238E27FC236}">
                    <a16:creationId xmlns:a16="http://schemas.microsoft.com/office/drawing/2014/main" id="{4DAF9DB1-54B6-4C4E-AE2E-A5025403BB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009385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52" name="Oval 39">
                <a:extLst>
                  <a:ext uri="{FF2B5EF4-FFF2-40B4-BE49-F238E27FC236}">
                    <a16:creationId xmlns:a16="http://schemas.microsoft.com/office/drawing/2014/main" id="{F27EE133-50B1-4A27-AB8B-4ADB3240EF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18559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53" name="Oval 40">
                <a:extLst>
                  <a:ext uri="{FF2B5EF4-FFF2-40B4-BE49-F238E27FC236}">
                    <a16:creationId xmlns:a16="http://schemas.microsoft.com/office/drawing/2014/main" id="{6AB8D9FF-AB27-4F67-9729-D3A1EF4DDA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07923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66" name="Oval 53">
                <a:extLst>
                  <a:ext uri="{FF2B5EF4-FFF2-40B4-BE49-F238E27FC236}">
                    <a16:creationId xmlns:a16="http://schemas.microsoft.com/office/drawing/2014/main" id="{615C1F97-1764-4349-8429-D2F88BC248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61739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67" name="Oval 54">
                <a:extLst>
                  <a:ext uri="{FF2B5EF4-FFF2-40B4-BE49-F238E27FC236}">
                    <a16:creationId xmlns:a16="http://schemas.microsoft.com/office/drawing/2014/main" id="{76C747FA-C80C-4906-AAD5-CDC6671EB5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79519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69" name="Oval 56">
                <a:extLst>
                  <a:ext uri="{FF2B5EF4-FFF2-40B4-BE49-F238E27FC236}">
                    <a16:creationId xmlns:a16="http://schemas.microsoft.com/office/drawing/2014/main" id="{2E230918-C971-447F-A100-B454380892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42848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70" name="Oval 57">
                <a:extLst>
                  <a:ext uri="{FF2B5EF4-FFF2-40B4-BE49-F238E27FC236}">
                    <a16:creationId xmlns:a16="http://schemas.microsoft.com/office/drawing/2014/main" id="{596762C6-C2FE-4E83-87F1-0C1E7E3393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63486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72" name="Oval 59">
                <a:extLst>
                  <a:ext uri="{FF2B5EF4-FFF2-40B4-BE49-F238E27FC236}">
                    <a16:creationId xmlns:a16="http://schemas.microsoft.com/office/drawing/2014/main" id="{036A3EDB-42AE-4C3C-9EFB-758C4CB667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42213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73" name="Oval 60">
                <a:extLst>
                  <a:ext uri="{FF2B5EF4-FFF2-40B4-BE49-F238E27FC236}">
                    <a16:creationId xmlns:a16="http://schemas.microsoft.com/office/drawing/2014/main" id="{CD09E965-ECD1-4091-9044-FB0AB176D1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4772847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76" name="Oval 63">
                <a:extLst>
                  <a:ext uri="{FF2B5EF4-FFF2-40B4-BE49-F238E27FC236}">
                    <a16:creationId xmlns:a16="http://schemas.microsoft.com/office/drawing/2014/main" id="{9CADEF94-3614-44D1-ABF9-F9287C07AD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61104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90" name="Oval 77">
                <a:extLst>
                  <a:ext uri="{FF2B5EF4-FFF2-40B4-BE49-F238E27FC236}">
                    <a16:creationId xmlns:a16="http://schemas.microsoft.com/office/drawing/2014/main" id="{3F72FD52-3662-4637-9C8B-DBE2CAD640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80631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91" name="Oval 78">
                <a:extLst>
                  <a:ext uri="{FF2B5EF4-FFF2-40B4-BE49-F238E27FC236}">
                    <a16:creationId xmlns:a16="http://schemas.microsoft.com/office/drawing/2014/main" id="{9D2B3256-DC34-4702-8141-7DCDBB05C3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50468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92" name="Oval 79">
                <a:extLst>
                  <a:ext uri="{FF2B5EF4-FFF2-40B4-BE49-F238E27FC236}">
                    <a16:creationId xmlns:a16="http://schemas.microsoft.com/office/drawing/2014/main" id="{5000E1D1-B851-4F1A-85B5-BD041AD3AF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67137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93" name="Oval 80">
                <a:extLst>
                  <a:ext uri="{FF2B5EF4-FFF2-40B4-BE49-F238E27FC236}">
                    <a16:creationId xmlns:a16="http://schemas.microsoft.com/office/drawing/2014/main" id="{333122FA-E938-4744-83E6-62C9C9BF55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656354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94" name="Oval 81">
                <a:extLst>
                  <a:ext uri="{FF2B5EF4-FFF2-40B4-BE49-F238E27FC236}">
                    <a16:creationId xmlns:a16="http://schemas.microsoft.com/office/drawing/2014/main" id="{EA0CB08E-B3D6-4656-8066-7820D6B165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65867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96" name="Oval 83">
                <a:extLst>
                  <a:ext uri="{FF2B5EF4-FFF2-40B4-BE49-F238E27FC236}">
                    <a16:creationId xmlns:a16="http://schemas.microsoft.com/office/drawing/2014/main" id="{81EFF4AF-1E81-4E5F-91F8-B1CA950712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61739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97" name="Oval 84">
                <a:extLst>
                  <a:ext uri="{FF2B5EF4-FFF2-40B4-BE49-F238E27FC236}">
                    <a16:creationId xmlns:a16="http://schemas.microsoft.com/office/drawing/2014/main" id="{A36AFD51-66A5-4194-B070-DEBBCDBDCC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718997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98" name="Oval 85">
                <a:extLst>
                  <a:ext uri="{FF2B5EF4-FFF2-40B4-BE49-F238E27FC236}">
                    <a16:creationId xmlns:a16="http://schemas.microsoft.com/office/drawing/2014/main" id="{72EDD214-E5A8-4FF9-A132-AD6422055F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622699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00" name="Oval 87">
                <a:extLst>
                  <a:ext uri="{FF2B5EF4-FFF2-40B4-BE49-F238E27FC236}">
                    <a16:creationId xmlns:a16="http://schemas.microsoft.com/office/drawing/2014/main" id="{3947F828-19CE-4E07-93BB-B9959E6A39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38086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13" name="Oval 100">
                <a:extLst>
                  <a:ext uri="{FF2B5EF4-FFF2-40B4-BE49-F238E27FC236}">
                    <a16:creationId xmlns:a16="http://schemas.microsoft.com/office/drawing/2014/main" id="{BB7768BC-E903-4650-8FA8-85E018312C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73646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16" name="Oval 103">
                <a:extLst>
                  <a:ext uri="{FF2B5EF4-FFF2-40B4-BE49-F238E27FC236}">
                    <a16:creationId xmlns:a16="http://schemas.microsoft.com/office/drawing/2014/main" id="{F860CCFA-0781-43DA-99AD-419FE0D9DF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94918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17" name="Oval 104">
                <a:extLst>
                  <a:ext uri="{FF2B5EF4-FFF2-40B4-BE49-F238E27FC236}">
                    <a16:creationId xmlns:a16="http://schemas.microsoft.com/office/drawing/2014/main" id="{A25CD80C-2ACA-4BA1-A0F2-412FAE3BE6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6020622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18" name="Oval 105">
                <a:extLst>
                  <a:ext uri="{FF2B5EF4-FFF2-40B4-BE49-F238E27FC236}">
                    <a16:creationId xmlns:a16="http://schemas.microsoft.com/office/drawing/2014/main" id="{042D659E-7B4B-4044-9FFF-709EF980A0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76503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22" name="Oval 109">
                <a:extLst>
                  <a:ext uri="{FF2B5EF4-FFF2-40B4-BE49-F238E27FC236}">
                    <a16:creationId xmlns:a16="http://schemas.microsoft.com/office/drawing/2014/main" id="{6178A070-20C1-4D6C-BA71-CC66F48B2B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99046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24" name="Oval 111">
                <a:extLst>
                  <a:ext uri="{FF2B5EF4-FFF2-40B4-BE49-F238E27FC236}">
                    <a16:creationId xmlns:a16="http://schemas.microsoft.com/office/drawing/2014/main" id="{76DF8BF3-6F90-48BC-821C-54883336AF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1181" y="5653910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48" name="Line 135">
                <a:extLst>
                  <a:ext uri="{FF2B5EF4-FFF2-40B4-BE49-F238E27FC236}">
                    <a16:creationId xmlns:a16="http://schemas.microsoft.com/office/drawing/2014/main" id="{C29E8B53-5F9E-4AD8-ACA6-9AC1E03409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84993" y="6706421"/>
                <a:ext cx="0" cy="3960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52" name="Rectangle 139">
                <a:extLst>
                  <a:ext uri="{FF2B5EF4-FFF2-40B4-BE49-F238E27FC236}">
                    <a16:creationId xmlns:a16="http://schemas.microsoft.com/office/drawing/2014/main" id="{E47BF812-9CED-457E-85FA-C42308EB25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99659" y="6786413"/>
                <a:ext cx="570669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de-DE" altLang="de-DE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kumimoji="0" lang="de-DE" altLang="de-DE" sz="1000" b="0" i="0" u="none" strike="noStrike" cap="none" normalizeH="0" baseline="0" dirty="0" err="1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ts+WCR</a:t>
                </a:r>
                <a:endParaRPr kumimoji="0" lang="de-DE" altLang="de-DE" sz="10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153" name="Rectangle 140">
              <a:extLst>
                <a:ext uri="{FF2B5EF4-FFF2-40B4-BE49-F238E27FC236}">
                  <a16:creationId xmlns:a16="http://schemas.microsoft.com/office/drawing/2014/main" id="{A0CB77F4-E322-4F0D-91DD-3B55872973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77278" y="6979888"/>
              <a:ext cx="535403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 err="1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reatments</a:t>
              </a:r>
              <a:endParaRPr kumimoji="0" lang="de-DE" altLang="de-DE" sz="10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54" name="Rectangle 141">
              <a:extLst>
                <a:ext uri="{FF2B5EF4-FFF2-40B4-BE49-F238E27FC236}">
                  <a16:creationId xmlns:a16="http://schemas.microsoft.com/office/drawing/2014/main" id="{DE40B552-7DD0-4EDC-8D38-D0748606464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39700" y="5334077"/>
              <a:ext cx="93455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 err="1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il</a:t>
              </a:r>
              <a:r>
                <a:rPr kumimoji="0" lang="de-DE" altLang="de-DE" sz="10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de-DE" altLang="de-DE" sz="1000" b="0" i="0" u="none" strike="noStrike" cap="none" normalizeH="0" baseline="0" dirty="0" err="1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ater</a:t>
              </a:r>
              <a:r>
                <a:rPr kumimoji="0" lang="de-DE" altLang="de-DE" sz="10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de-DE" altLang="de-DE" sz="1000" b="0" i="0" u="none" strike="noStrike" cap="none" normalizeH="0" baseline="0" dirty="0" err="1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ontent</a:t>
              </a:r>
              <a:endParaRPr kumimoji="0" lang="de-DE" altLang="de-DE" sz="10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197" name="Gruppieren 5196">
              <a:extLst>
                <a:ext uri="{FF2B5EF4-FFF2-40B4-BE49-F238E27FC236}">
                  <a16:creationId xmlns:a16="http://schemas.microsoft.com/office/drawing/2014/main" id="{88FB2E36-968A-4536-BD0B-DC3A0702B954}"/>
                </a:ext>
              </a:extLst>
            </p:cNvPr>
            <p:cNvGrpSpPr/>
            <p:nvPr/>
          </p:nvGrpSpPr>
          <p:grpSpPr>
            <a:xfrm>
              <a:off x="3965327" y="4475985"/>
              <a:ext cx="206788" cy="2464316"/>
              <a:chOff x="3923532" y="4475985"/>
              <a:chExt cx="206788" cy="2464316"/>
            </a:xfrm>
          </p:grpSpPr>
          <p:sp>
            <p:nvSpPr>
              <p:cNvPr id="5170" name="Oval 18">
                <a:extLst>
                  <a:ext uri="{FF2B5EF4-FFF2-40B4-BE49-F238E27FC236}">
                    <a16:creationId xmlns:a16="http://schemas.microsoft.com/office/drawing/2014/main" id="{E97824C5-C2E8-4918-A9A2-AFBC2D224E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447598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71" name="Oval 20">
                <a:extLst>
                  <a:ext uri="{FF2B5EF4-FFF2-40B4-BE49-F238E27FC236}">
                    <a16:creationId xmlns:a16="http://schemas.microsoft.com/office/drawing/2014/main" id="{21525327-C121-48E5-8EBE-3EB840AC07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492524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72" name="Oval 23">
                <a:extLst>
                  <a:ext uri="{FF2B5EF4-FFF2-40B4-BE49-F238E27FC236}">
                    <a16:creationId xmlns:a16="http://schemas.microsoft.com/office/drawing/2014/main" id="{AFFB7905-2A05-48D1-90A7-EE77251FF0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490778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73" name="Oval 24">
                <a:extLst>
                  <a:ext uri="{FF2B5EF4-FFF2-40B4-BE49-F238E27FC236}">
                    <a16:creationId xmlns:a16="http://schemas.microsoft.com/office/drawing/2014/main" id="{B13E29D4-3B7C-485F-9B8A-F36B8AB7FC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471252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74" name="Oval 25">
                <a:extLst>
                  <a:ext uri="{FF2B5EF4-FFF2-40B4-BE49-F238E27FC236}">
                    <a16:creationId xmlns:a16="http://schemas.microsoft.com/office/drawing/2014/main" id="{A18E9DDF-13DD-4019-B935-BB851B6970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552849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75" name="Oval 41">
                <a:extLst>
                  <a:ext uri="{FF2B5EF4-FFF2-40B4-BE49-F238E27FC236}">
                    <a16:creationId xmlns:a16="http://schemas.microsoft.com/office/drawing/2014/main" id="{D7BCE7C7-4044-4100-B33F-54E976995C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521576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76" name="Oval 42">
                <a:extLst>
                  <a:ext uri="{FF2B5EF4-FFF2-40B4-BE49-F238E27FC236}">
                    <a16:creationId xmlns:a16="http://schemas.microsoft.com/office/drawing/2014/main" id="{F8BAFFD6-4F36-4405-9A83-44BFECC233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5825360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77" name="Oval 43">
                <a:extLst>
                  <a:ext uri="{FF2B5EF4-FFF2-40B4-BE49-F238E27FC236}">
                    <a16:creationId xmlns:a16="http://schemas.microsoft.com/office/drawing/2014/main" id="{4FD20501-DFA0-425A-B4C6-9D57361AD8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512686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78" name="Oval 45">
                <a:extLst>
                  <a:ext uri="{FF2B5EF4-FFF2-40B4-BE49-F238E27FC236}">
                    <a16:creationId xmlns:a16="http://schemas.microsoft.com/office/drawing/2014/main" id="{C713D936-77DA-4535-82BC-1DF045FCB7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5630097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79" name="Oval 50">
                <a:extLst>
                  <a:ext uri="{FF2B5EF4-FFF2-40B4-BE49-F238E27FC236}">
                    <a16:creationId xmlns:a16="http://schemas.microsoft.com/office/drawing/2014/main" id="{DEC091B6-FA6B-49EF-A030-11ECDC3F1D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536339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80" name="Oval 51">
                <a:extLst>
                  <a:ext uri="{FF2B5EF4-FFF2-40B4-BE49-F238E27FC236}">
                    <a16:creationId xmlns:a16="http://schemas.microsoft.com/office/drawing/2014/main" id="{A4A09D5A-D5DB-4718-938C-F46638ACC6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520306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81" name="Oval 64">
                <a:extLst>
                  <a:ext uri="{FF2B5EF4-FFF2-40B4-BE49-F238E27FC236}">
                    <a16:creationId xmlns:a16="http://schemas.microsoft.com/office/drawing/2014/main" id="{D7BAC7FB-E4F1-49F6-848A-975FEBC6A4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565867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82" name="Oval 67">
                <a:extLst>
                  <a:ext uri="{FF2B5EF4-FFF2-40B4-BE49-F238E27FC236}">
                    <a16:creationId xmlns:a16="http://schemas.microsoft.com/office/drawing/2014/main" id="{C1EE4A7B-6B97-4AF5-83AD-DDF51EC8E9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569994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83" name="Oval 73">
                <a:extLst>
                  <a:ext uri="{FF2B5EF4-FFF2-40B4-BE49-F238E27FC236}">
                    <a16:creationId xmlns:a16="http://schemas.microsoft.com/office/drawing/2014/main" id="{5469C87E-99C4-4D01-9A98-1D74B2C3F1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554119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84" name="Oval 88">
                <a:extLst>
                  <a:ext uri="{FF2B5EF4-FFF2-40B4-BE49-F238E27FC236}">
                    <a16:creationId xmlns:a16="http://schemas.microsoft.com/office/drawing/2014/main" id="{77519A32-3010-468B-8D69-D1D56EE3A9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555866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85" name="Oval 90">
                <a:extLst>
                  <a:ext uri="{FF2B5EF4-FFF2-40B4-BE49-F238E27FC236}">
                    <a16:creationId xmlns:a16="http://schemas.microsoft.com/office/drawing/2014/main" id="{F7FD8FE8-2F5B-4718-B02E-FE2EF47B92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5830122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86" name="Oval 93">
                <a:extLst>
                  <a:ext uri="{FF2B5EF4-FFF2-40B4-BE49-F238E27FC236}">
                    <a16:creationId xmlns:a16="http://schemas.microsoft.com/office/drawing/2014/main" id="{94FD5FE0-33E4-4491-8447-EDFFB27AFD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584758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87" name="Oval 94">
                <a:extLst>
                  <a:ext uri="{FF2B5EF4-FFF2-40B4-BE49-F238E27FC236}">
                    <a16:creationId xmlns:a16="http://schemas.microsoft.com/office/drawing/2014/main" id="{D77AB480-F3DA-41B8-95B4-349B91523D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5558660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88" name="Oval 96">
                <a:extLst>
                  <a:ext uri="{FF2B5EF4-FFF2-40B4-BE49-F238E27FC236}">
                    <a16:creationId xmlns:a16="http://schemas.microsoft.com/office/drawing/2014/main" id="{68497046-6FF2-4DC8-8501-675719CF2F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561739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89" name="Oval 97">
                <a:extLst>
                  <a:ext uri="{FF2B5EF4-FFF2-40B4-BE49-F238E27FC236}">
                    <a16:creationId xmlns:a16="http://schemas.microsoft.com/office/drawing/2014/main" id="{19B5FA5C-C12A-40AE-9A7C-5E2B9AFC33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568248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90" name="Oval 115">
                <a:extLst>
                  <a:ext uri="{FF2B5EF4-FFF2-40B4-BE49-F238E27FC236}">
                    <a16:creationId xmlns:a16="http://schemas.microsoft.com/office/drawing/2014/main" id="{8127D52B-C177-4B60-9217-A63DA5AA5D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5801547"/>
                <a:ext cx="47625" cy="46038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91" name="Oval 116">
                <a:extLst>
                  <a:ext uri="{FF2B5EF4-FFF2-40B4-BE49-F238E27FC236}">
                    <a16:creationId xmlns:a16="http://schemas.microsoft.com/office/drawing/2014/main" id="{6E2E5D38-1D86-4771-A04C-531E8D9350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5860285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92" name="Oval 120">
                <a:extLst>
                  <a:ext uri="{FF2B5EF4-FFF2-40B4-BE49-F238E27FC236}">
                    <a16:creationId xmlns:a16="http://schemas.microsoft.com/office/drawing/2014/main" id="{F4626ED8-0E64-4516-92E3-DD817C2603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3114" y="5699947"/>
                <a:ext cx="47625" cy="47625"/>
              </a:xfrm>
              <a:prstGeom prst="ellipse">
                <a:avLst/>
              </a:prstGeom>
              <a:solidFill>
                <a:schemeClr val="tx1"/>
              </a:solidFill>
              <a:ln w="3810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93" name="Line 133">
                <a:extLst>
                  <a:ext uri="{FF2B5EF4-FFF2-40B4-BE49-F238E27FC236}">
                    <a16:creationId xmlns:a16="http://schemas.microsoft.com/office/drawing/2014/main" id="{D2CBD76D-A46C-4CFE-91F2-8F2887D97B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26926" y="6706421"/>
                <a:ext cx="0" cy="3960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94" name="Rectangle 137">
                <a:extLst>
                  <a:ext uri="{FF2B5EF4-FFF2-40B4-BE49-F238E27FC236}">
                    <a16:creationId xmlns:a16="http://schemas.microsoft.com/office/drawing/2014/main" id="{CBC209F6-47D6-4258-A5AA-E8171366BA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23532" y="6786413"/>
                <a:ext cx="206788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000" b="0" i="0" u="none" strike="noStrike" cap="none" normalizeH="0" baseline="0" dirty="0" err="1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t</a:t>
                </a:r>
                <a:r>
                  <a:rPr lang="de-DE" altLang="de-DE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</a:t>
                </a:r>
                <a:endParaRPr kumimoji="0" lang="de-DE" altLang="de-DE" sz="10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200" name="Line 130">
              <a:extLst>
                <a:ext uri="{FF2B5EF4-FFF2-40B4-BE49-F238E27FC236}">
                  <a16:creationId xmlns:a16="http://schemas.microsoft.com/office/drawing/2014/main" id="{6282E3C7-0F4D-4302-945F-08AED3F1BB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66493" y="4115622"/>
              <a:ext cx="39600" cy="0"/>
            </a:xfrm>
            <a:prstGeom prst="line">
              <a:avLst/>
            </a:prstGeom>
            <a:noFill/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01" name="Rectangle 127">
              <a:extLst>
                <a:ext uri="{FF2B5EF4-FFF2-40B4-BE49-F238E27FC236}">
                  <a16:creationId xmlns:a16="http://schemas.microsoft.com/office/drawing/2014/main" id="{D1F94F1D-106D-4FB7-B1FA-195C60E056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0761" y="4041420"/>
              <a:ext cx="22442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67392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64899356"/>
              </p:ext>
            </p:extLst>
          </p:nvPr>
        </p:nvGraphicFramePr>
        <p:xfrm>
          <a:off x="471488" y="840553"/>
          <a:ext cx="288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Rectangle 3"/>
          <p:cNvSpPr/>
          <p:nvPr/>
        </p:nvSpPr>
        <p:spPr>
          <a:xfrm>
            <a:off x="139320" y="70100"/>
            <a:ext cx="10887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57620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Diagramm 7">
            <a:extLst>
              <a:ext uri="{FF2B5EF4-FFF2-40B4-BE49-F238E27FC236}">
                <a16:creationId xmlns:a16="http://schemas.microsoft.com/office/drawing/2014/main" id="{C83831EA-700A-4861-B687-9063427FF42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4490410"/>
              </p:ext>
            </p:extLst>
          </p:nvPr>
        </p:nvGraphicFramePr>
        <p:xfrm>
          <a:off x="471488" y="840553"/>
          <a:ext cx="59184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Rectangle 8"/>
          <p:cNvSpPr/>
          <p:nvPr/>
        </p:nvSpPr>
        <p:spPr>
          <a:xfrm>
            <a:off x="139320" y="70100"/>
            <a:ext cx="1088760" cy="369332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55270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655" t="5636" r="4230" b="26400"/>
          <a:stretch/>
        </p:blipFill>
        <p:spPr>
          <a:xfrm rot="5400000">
            <a:off x="776457" y="961611"/>
            <a:ext cx="2271600" cy="2877912"/>
          </a:xfrm>
          <a:prstGeom prst="rect">
            <a:avLst/>
          </a:prstGeom>
        </p:spPr>
      </p:pic>
      <p:sp>
        <p:nvSpPr>
          <p:cNvPr id="29" name="Rectangle 28"/>
          <p:cNvSpPr/>
          <p:nvPr/>
        </p:nvSpPr>
        <p:spPr>
          <a:xfrm>
            <a:off x="473301" y="3673064"/>
            <a:ext cx="312906" cy="276999"/>
          </a:xfrm>
          <a:prstGeom prst="rect">
            <a:avLst/>
          </a:prstGeom>
          <a:noFill/>
          <a:ln>
            <a:noFill/>
          </a:ln>
        </p:spPr>
        <p:txBody>
          <a:bodyPr wrap="none" rtlCol="0" anchor="ctr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sp>
        <p:nvSpPr>
          <p:cNvPr id="31" name="Rectangle 30"/>
          <p:cNvSpPr/>
          <p:nvPr/>
        </p:nvSpPr>
        <p:spPr>
          <a:xfrm>
            <a:off x="473301" y="851071"/>
            <a:ext cx="304892" cy="276999"/>
          </a:xfrm>
          <a:prstGeom prst="rect">
            <a:avLst/>
          </a:prstGeom>
          <a:noFill/>
          <a:ln>
            <a:noFill/>
          </a:ln>
        </p:spPr>
        <p:txBody>
          <a:bodyPr wrap="none" rtlCol="0" anchor="ctr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9" name="Rectangle 8"/>
          <p:cNvSpPr/>
          <p:nvPr/>
        </p:nvSpPr>
        <p:spPr>
          <a:xfrm>
            <a:off x="139320" y="70100"/>
            <a:ext cx="10887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9738124"/>
              </p:ext>
            </p:extLst>
          </p:nvPr>
        </p:nvGraphicFramePr>
        <p:xfrm>
          <a:off x="471482" y="4086761"/>
          <a:ext cx="5915037" cy="884304"/>
        </p:xfrm>
        <a:graphic>
          <a:graphicData uri="http://schemas.openxmlformats.org/drawingml/2006/table">
            <a:tbl>
              <a:tblPr/>
              <a:tblGrid>
                <a:gridCol w="137559">
                  <a:extLst>
                    <a:ext uri="{9D8B030D-6E8A-4147-A177-3AD203B41FA5}">
                      <a16:colId xmlns:a16="http://schemas.microsoft.com/office/drawing/2014/main" val="4079461952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428959367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4054101725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1265570397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4103773003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4023063664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358448893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2331271872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2228322495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3847775097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1602629374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3180066458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2127777095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2386509659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2987212757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3600041964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1589068917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2527725284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1294682117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4285426451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99859361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3238201142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3212597405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528530063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1520474203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3827873576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2387028190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1690023961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2459941080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2179972215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3232914924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2603038847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2295495231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2014532863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631127936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4037466651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1959730301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1619078570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209485484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2824726989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4213653767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1553220839"/>
                    </a:ext>
                  </a:extLst>
                </a:gridCol>
                <a:gridCol w="137559">
                  <a:extLst>
                    <a:ext uri="{9D8B030D-6E8A-4147-A177-3AD203B41FA5}">
                      <a16:colId xmlns:a16="http://schemas.microsoft.com/office/drawing/2014/main" val="2137405040"/>
                    </a:ext>
                  </a:extLst>
                </a:gridCol>
              </a:tblGrid>
              <a:tr h="1473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927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927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8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3887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6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83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29A7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8D7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83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29A7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6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6F6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8D7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8D7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927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8715424"/>
                  </a:ext>
                </a:extLst>
              </a:tr>
              <a:tr h="1473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4913" marR="4913" marT="491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927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9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80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6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7A6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29A7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29A7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5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766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6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7A6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29A7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8D7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8D7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987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8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80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2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83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29A7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6859257"/>
                  </a:ext>
                </a:extLst>
              </a:tr>
              <a:tr h="1473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29A7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8D7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8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3887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766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987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5273303"/>
                  </a:ext>
                </a:extLst>
              </a:tr>
              <a:tr h="1473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8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80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A7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927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4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83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5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4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80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29A7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3887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2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7A6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4900010"/>
                  </a:ext>
                </a:extLst>
              </a:tr>
              <a:tr h="1473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1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6F6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8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6F6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9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766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1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7A6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29A7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3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6F6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83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8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06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06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56284205"/>
                  </a:ext>
                </a:extLst>
              </a:tr>
              <a:tr h="1473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</a:t>
                      </a:r>
                    </a:p>
                  </a:txBody>
                  <a:tcPr marL="4913" marR="4913" marT="491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987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9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7A6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7A6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7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83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A7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83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4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83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9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6F6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1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3887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8C7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8D7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4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83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4913" marR="4913" marT="4913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632703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475510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Diagramm 5">
            <a:extLst>
              <a:ext uri="{FF2B5EF4-FFF2-40B4-BE49-F238E27FC236}">
                <a16:creationId xmlns:a16="http://schemas.microsoft.com/office/drawing/2014/main" id="{00000000-0008-0000-0100-000006000000}"/>
              </a:ext>
            </a:extLst>
          </p:cNvPr>
          <p:cNvGraphicFramePr>
            <a:graphicFrameLocks noGrp="1"/>
          </p:cNvGraphicFramePr>
          <p:nvPr>
            <p:ph idx="13"/>
            <p:extLst>
              <p:ext uri="{D42A27DB-BD31-4B8C-83A1-F6EECF244321}">
                <p14:modId xmlns:p14="http://schemas.microsoft.com/office/powerpoint/2010/main" val="4106768827"/>
              </p:ext>
            </p:extLst>
          </p:nvPr>
        </p:nvGraphicFramePr>
        <p:xfrm>
          <a:off x="471488" y="840553"/>
          <a:ext cx="5918400" cy="28813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Rectangle 3"/>
          <p:cNvSpPr/>
          <p:nvPr/>
        </p:nvSpPr>
        <p:spPr>
          <a:xfrm>
            <a:off x="139320" y="70100"/>
            <a:ext cx="10887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</a:p>
        </p:txBody>
      </p:sp>
    </p:spTree>
    <p:extLst>
      <p:ext uri="{BB962C8B-B14F-4D97-AF65-F5344CB8AC3E}">
        <p14:creationId xmlns:p14="http://schemas.microsoft.com/office/powerpoint/2010/main" val="566468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199</Words>
  <Application>Microsoft Office PowerPoint</Application>
  <PresentationFormat>A4 Paper (210x297 mm)</PresentationFormat>
  <Paragraphs>298</Paragraphs>
  <Slides>6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ouk Guyer</dc:creator>
  <cp:lastModifiedBy>Anouk Guyer</cp:lastModifiedBy>
  <cp:revision>389</cp:revision>
  <cp:lastPrinted>2017-03-31T07:41:10Z</cp:lastPrinted>
  <dcterms:created xsi:type="dcterms:W3CDTF">2017-02-15T15:00:34Z</dcterms:created>
  <dcterms:modified xsi:type="dcterms:W3CDTF">2018-03-07T07:33:01Z</dcterms:modified>
</cp:coreProperties>
</file>